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10" r:id="rId2"/>
    <p:sldId id="311" r:id="rId3"/>
    <p:sldId id="314" r:id="rId4"/>
    <p:sldId id="280" r:id="rId5"/>
    <p:sldId id="27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34" autoAdjust="0"/>
    <p:restoredTop sz="94660"/>
  </p:normalViewPr>
  <p:slideViewPr>
    <p:cSldViewPr snapToGrid="0">
      <p:cViewPr varScale="1">
        <p:scale>
          <a:sx n="55" d="100"/>
          <a:sy n="55" d="100"/>
        </p:scale>
        <p:origin x="318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E:\&#32933;&#28288;&#20816;&#12450;&#12511;&#12494;&#37240;&#35542;&#25991;\&#23567;&#20816;&#32933;&#28288;&#12487;&#12540;&#12479;%20%232(181027%20&#20316;&#25104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E:\&#32933;&#28288;&#20816;&#12450;&#12511;&#12494;&#37240;&#35542;&#25991;\&#23567;&#20816;&#32933;&#28288;&#12487;&#12540;&#12479;%20%232(181027%20&#20316;&#25104;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E:\&#32933;&#28288;&#20816;&#12450;&#12511;&#12494;&#37240;&#35542;&#25991;\&#23567;&#20816;&#32933;&#28288;&#12487;&#12540;&#12479;%20%232(181027%20&#20316;&#25104;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540277777777779E-2"/>
          <c:y val="3.8752777777777775E-2"/>
          <c:w val="0.88488819444444444"/>
          <c:h val="0.88901655937427604"/>
        </c:manualLayout>
      </c:layout>
      <c:scatterChart>
        <c:scatterStyle val="lineMarker"/>
        <c:varyColors val="0"/>
        <c:ser>
          <c:idx val="0"/>
          <c:order val="0"/>
          <c:tx>
            <c:strRef>
              <c:f>全体!$I$1</c:f>
              <c:strCache>
                <c:ptCount val="1"/>
                <c:pt idx="0">
                  <c:v>IMT-rt (mm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28575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全体!$I$2:$I$27</c:f>
              <c:numCache>
                <c:formatCode>General</c:formatCode>
                <c:ptCount val="26"/>
                <c:pt idx="0">
                  <c:v>0.53</c:v>
                </c:pt>
                <c:pt idx="1">
                  <c:v>0.63</c:v>
                </c:pt>
                <c:pt idx="2">
                  <c:v>0.43</c:v>
                </c:pt>
                <c:pt idx="3">
                  <c:v>0.46</c:v>
                </c:pt>
                <c:pt idx="4">
                  <c:v>0.56999999999999995</c:v>
                </c:pt>
                <c:pt idx="5">
                  <c:v>0.6</c:v>
                </c:pt>
                <c:pt idx="6">
                  <c:v>0.67</c:v>
                </c:pt>
                <c:pt idx="7">
                  <c:v>0.47</c:v>
                </c:pt>
                <c:pt idx="8">
                  <c:v>0.5</c:v>
                </c:pt>
                <c:pt idx="9">
                  <c:v>0.54</c:v>
                </c:pt>
                <c:pt idx="10">
                  <c:v>0.64</c:v>
                </c:pt>
                <c:pt idx="11">
                  <c:v>0.66</c:v>
                </c:pt>
                <c:pt idx="12">
                  <c:v>0.52</c:v>
                </c:pt>
                <c:pt idx="13">
                  <c:v>0.6</c:v>
                </c:pt>
                <c:pt idx="14">
                  <c:v>0.54</c:v>
                </c:pt>
                <c:pt idx="15">
                  <c:v>0.56999999999999995</c:v>
                </c:pt>
                <c:pt idx="16">
                  <c:v>0.5</c:v>
                </c:pt>
                <c:pt idx="17">
                  <c:v>0.4</c:v>
                </c:pt>
                <c:pt idx="18">
                  <c:v>0.5</c:v>
                </c:pt>
                <c:pt idx="19">
                  <c:v>0.5</c:v>
                </c:pt>
                <c:pt idx="20">
                  <c:v>0.56000000000000005</c:v>
                </c:pt>
                <c:pt idx="21">
                  <c:v>0.57999999999999996</c:v>
                </c:pt>
                <c:pt idx="22">
                  <c:v>0.57999999999999996</c:v>
                </c:pt>
                <c:pt idx="23">
                  <c:v>0.5</c:v>
                </c:pt>
                <c:pt idx="24">
                  <c:v>0.47</c:v>
                </c:pt>
                <c:pt idx="25">
                  <c:v>0.5</c:v>
                </c:pt>
              </c:numCache>
            </c:numRef>
          </c:xVal>
          <c:yVal>
            <c:numRef>
              <c:f>全体!$AH$2:$AH$27</c:f>
              <c:numCache>
                <c:formatCode>General</c:formatCode>
                <c:ptCount val="26"/>
                <c:pt idx="0">
                  <c:v>2.6</c:v>
                </c:pt>
                <c:pt idx="1">
                  <c:v>2.9</c:v>
                </c:pt>
                <c:pt idx="2">
                  <c:v>1.3</c:v>
                </c:pt>
                <c:pt idx="3">
                  <c:v>1.5</c:v>
                </c:pt>
                <c:pt idx="4">
                  <c:v>2.7</c:v>
                </c:pt>
                <c:pt idx="5">
                  <c:v>1.7</c:v>
                </c:pt>
                <c:pt idx="6">
                  <c:v>2</c:v>
                </c:pt>
                <c:pt idx="7">
                  <c:v>2.4</c:v>
                </c:pt>
                <c:pt idx="8">
                  <c:v>2.7</c:v>
                </c:pt>
                <c:pt idx="9">
                  <c:v>2</c:v>
                </c:pt>
                <c:pt idx="10">
                  <c:v>4.9000000000000004</c:v>
                </c:pt>
                <c:pt idx="11">
                  <c:v>3.4</c:v>
                </c:pt>
                <c:pt idx="12">
                  <c:v>1.6</c:v>
                </c:pt>
                <c:pt idx="13">
                  <c:v>2.2999999999999998</c:v>
                </c:pt>
                <c:pt idx="14">
                  <c:v>2.9</c:v>
                </c:pt>
                <c:pt idx="15">
                  <c:v>2.5</c:v>
                </c:pt>
                <c:pt idx="16">
                  <c:v>2.5</c:v>
                </c:pt>
                <c:pt idx="17">
                  <c:v>1.5</c:v>
                </c:pt>
                <c:pt idx="18">
                  <c:v>1.9</c:v>
                </c:pt>
                <c:pt idx="19">
                  <c:v>3</c:v>
                </c:pt>
                <c:pt idx="20">
                  <c:v>1.6</c:v>
                </c:pt>
                <c:pt idx="21">
                  <c:v>3.2</c:v>
                </c:pt>
                <c:pt idx="22">
                  <c:v>3.1</c:v>
                </c:pt>
                <c:pt idx="23">
                  <c:v>2.2000000000000002</c:v>
                </c:pt>
                <c:pt idx="24">
                  <c:v>1.7</c:v>
                </c:pt>
                <c:pt idx="25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CF1-4B12-BFA1-2A2EC61736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0590976"/>
        <c:axId val="-2090262448"/>
      </c:scatterChart>
      <c:valAx>
        <c:axId val="-2090590976"/>
        <c:scaling>
          <c:orientation val="minMax"/>
          <c:max val="0.75000000000000011"/>
          <c:min val="0.35000000000000003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090262448"/>
        <c:crosses val="autoZero"/>
        <c:crossBetween val="midCat"/>
        <c:majorUnit val="0.1"/>
      </c:valAx>
      <c:valAx>
        <c:axId val="-20902624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090590976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1019943974049726E-2"/>
          <c:y val="2.5721647925932865E-2"/>
          <c:w val="0.92568682448706574"/>
          <c:h val="0.88905527379515159"/>
        </c:manualLayout>
      </c:layout>
      <c:scatterChart>
        <c:scatterStyle val="lineMarker"/>
        <c:varyColors val="0"/>
        <c:ser>
          <c:idx val="0"/>
          <c:order val="0"/>
          <c:tx>
            <c:strRef>
              <c:f>全体!$J$1</c:f>
              <c:strCache>
                <c:ptCount val="1"/>
                <c:pt idx="0">
                  <c:v>IMT-lt (mm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28575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全体!$J$2:$J$27</c:f>
              <c:numCache>
                <c:formatCode>General</c:formatCode>
                <c:ptCount val="26"/>
                <c:pt idx="0">
                  <c:v>0.6</c:v>
                </c:pt>
                <c:pt idx="1">
                  <c:v>0.63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6</c:v>
                </c:pt>
                <c:pt idx="6">
                  <c:v>0.56999999999999995</c:v>
                </c:pt>
                <c:pt idx="7">
                  <c:v>0.53</c:v>
                </c:pt>
                <c:pt idx="8">
                  <c:v>0.5</c:v>
                </c:pt>
                <c:pt idx="9">
                  <c:v>0.5</c:v>
                </c:pt>
                <c:pt idx="10">
                  <c:v>0.4</c:v>
                </c:pt>
                <c:pt idx="11">
                  <c:v>0.67</c:v>
                </c:pt>
                <c:pt idx="12">
                  <c:v>0.48</c:v>
                </c:pt>
                <c:pt idx="13">
                  <c:v>0.5</c:v>
                </c:pt>
                <c:pt idx="14">
                  <c:v>0.64</c:v>
                </c:pt>
                <c:pt idx="15">
                  <c:v>0.6</c:v>
                </c:pt>
                <c:pt idx="16">
                  <c:v>0.6</c:v>
                </c:pt>
                <c:pt idx="17">
                  <c:v>0.43</c:v>
                </c:pt>
                <c:pt idx="18">
                  <c:v>0.46</c:v>
                </c:pt>
                <c:pt idx="19">
                  <c:v>0.6</c:v>
                </c:pt>
                <c:pt idx="20">
                  <c:v>0.53</c:v>
                </c:pt>
                <c:pt idx="21">
                  <c:v>0.69</c:v>
                </c:pt>
                <c:pt idx="22">
                  <c:v>0.52</c:v>
                </c:pt>
                <c:pt idx="23">
                  <c:v>0.6</c:v>
                </c:pt>
                <c:pt idx="24">
                  <c:v>0.53</c:v>
                </c:pt>
                <c:pt idx="25">
                  <c:v>0.55000000000000004</c:v>
                </c:pt>
              </c:numCache>
            </c:numRef>
          </c:xVal>
          <c:yVal>
            <c:numRef>
              <c:f>全体!$AH$2:$AH$27</c:f>
              <c:numCache>
                <c:formatCode>General</c:formatCode>
                <c:ptCount val="26"/>
                <c:pt idx="0">
                  <c:v>2.6</c:v>
                </c:pt>
                <c:pt idx="1">
                  <c:v>2.9</c:v>
                </c:pt>
                <c:pt idx="2">
                  <c:v>1.3</c:v>
                </c:pt>
                <c:pt idx="3">
                  <c:v>1.5</c:v>
                </c:pt>
                <c:pt idx="4">
                  <c:v>2.7</c:v>
                </c:pt>
                <c:pt idx="5">
                  <c:v>1.7</c:v>
                </c:pt>
                <c:pt idx="6">
                  <c:v>2</c:v>
                </c:pt>
                <c:pt idx="7">
                  <c:v>2.4</c:v>
                </c:pt>
                <c:pt idx="8">
                  <c:v>2.7</c:v>
                </c:pt>
                <c:pt idx="9">
                  <c:v>2</c:v>
                </c:pt>
                <c:pt idx="10">
                  <c:v>4.9000000000000004</c:v>
                </c:pt>
                <c:pt idx="11">
                  <c:v>3.4</c:v>
                </c:pt>
                <c:pt idx="12">
                  <c:v>1.6</c:v>
                </c:pt>
                <c:pt idx="13">
                  <c:v>2.2999999999999998</c:v>
                </c:pt>
                <c:pt idx="14">
                  <c:v>2.9</c:v>
                </c:pt>
                <c:pt idx="15">
                  <c:v>2.5</c:v>
                </c:pt>
                <c:pt idx="16">
                  <c:v>2.5</c:v>
                </c:pt>
                <c:pt idx="17">
                  <c:v>1.5</c:v>
                </c:pt>
                <c:pt idx="18">
                  <c:v>1.9</c:v>
                </c:pt>
                <c:pt idx="19">
                  <c:v>3</c:v>
                </c:pt>
                <c:pt idx="20">
                  <c:v>1.6</c:v>
                </c:pt>
                <c:pt idx="21">
                  <c:v>3.2</c:v>
                </c:pt>
                <c:pt idx="22">
                  <c:v>3.1</c:v>
                </c:pt>
                <c:pt idx="23">
                  <c:v>2.2000000000000002</c:v>
                </c:pt>
                <c:pt idx="24">
                  <c:v>1.7</c:v>
                </c:pt>
                <c:pt idx="25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85E-4EC9-BB6D-DC3464C63E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4208432"/>
        <c:axId val="-2074265936"/>
      </c:scatterChart>
      <c:valAx>
        <c:axId val="-2094208432"/>
        <c:scaling>
          <c:orientation val="minMax"/>
          <c:max val="0.75000000000000011"/>
          <c:min val="0.35000000000000003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074265936"/>
        <c:crosses val="autoZero"/>
        <c:crossBetween val="midCat"/>
        <c:majorUnit val="0.1"/>
      </c:valAx>
      <c:valAx>
        <c:axId val="-2074265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094208432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1019943974049726E-2"/>
          <c:y val="2.5730623554946343E-2"/>
          <c:w val="0.92568682448706574"/>
          <c:h val="0.88901655937427604"/>
        </c:manualLayout>
      </c:layout>
      <c:scatterChart>
        <c:scatterStyle val="lineMarker"/>
        <c:varyColors val="0"/>
        <c:ser>
          <c:idx val="0"/>
          <c:order val="0"/>
          <c:tx>
            <c:strRef>
              <c:f>全体!$K$1</c:f>
              <c:strCache>
                <c:ptCount val="1"/>
                <c:pt idx="0">
                  <c:v>IMT (Ave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noFill/>
              <a:ln w="19050">
                <a:solidFill>
                  <a:schemeClr val="tx1"/>
                </a:solidFill>
              </a:ln>
              <a:effectLst/>
            </c:spPr>
          </c:marker>
          <c:trendline>
            <c:spPr>
              <a:ln w="28575" cap="rnd">
                <a:solidFill>
                  <a:schemeClr val="tx1"/>
                </a:solidFill>
                <a:prstDash val="sysDash"/>
              </a:ln>
              <a:effectLst/>
            </c:spPr>
            <c:trendlineType val="linear"/>
            <c:dispRSqr val="0"/>
            <c:dispEq val="0"/>
          </c:trendline>
          <c:xVal>
            <c:numRef>
              <c:f>全体!$K$2:$K$27</c:f>
              <c:numCache>
                <c:formatCode>General</c:formatCode>
                <c:ptCount val="26"/>
                <c:pt idx="0">
                  <c:v>0.56499999999999995</c:v>
                </c:pt>
                <c:pt idx="1">
                  <c:v>0.63</c:v>
                </c:pt>
                <c:pt idx="2">
                  <c:v>0.46499999999999997</c:v>
                </c:pt>
                <c:pt idx="3">
                  <c:v>0.48</c:v>
                </c:pt>
                <c:pt idx="4">
                  <c:v>0.53499999999999992</c:v>
                </c:pt>
                <c:pt idx="5">
                  <c:v>0.6</c:v>
                </c:pt>
                <c:pt idx="6">
                  <c:v>0.62</c:v>
                </c:pt>
                <c:pt idx="7">
                  <c:v>0.5</c:v>
                </c:pt>
                <c:pt idx="8">
                  <c:v>0.5</c:v>
                </c:pt>
                <c:pt idx="9">
                  <c:v>0.52</c:v>
                </c:pt>
                <c:pt idx="10">
                  <c:v>0.52</c:v>
                </c:pt>
                <c:pt idx="11">
                  <c:v>0.66500000000000004</c:v>
                </c:pt>
                <c:pt idx="12">
                  <c:v>0.5</c:v>
                </c:pt>
                <c:pt idx="13">
                  <c:v>0.55000000000000004</c:v>
                </c:pt>
                <c:pt idx="14">
                  <c:v>0.59000000000000008</c:v>
                </c:pt>
                <c:pt idx="15">
                  <c:v>0.58499999999999996</c:v>
                </c:pt>
                <c:pt idx="16">
                  <c:v>0.55000000000000004</c:v>
                </c:pt>
                <c:pt idx="17">
                  <c:v>0.41500000000000004</c:v>
                </c:pt>
                <c:pt idx="18">
                  <c:v>0.48</c:v>
                </c:pt>
                <c:pt idx="19">
                  <c:v>0.55000000000000004</c:v>
                </c:pt>
                <c:pt idx="20">
                  <c:v>0.54500000000000004</c:v>
                </c:pt>
                <c:pt idx="21">
                  <c:v>0.63500000000000001</c:v>
                </c:pt>
                <c:pt idx="22">
                  <c:v>0.55000000000000004</c:v>
                </c:pt>
                <c:pt idx="23">
                  <c:v>0.55000000000000004</c:v>
                </c:pt>
                <c:pt idx="24">
                  <c:v>0.5</c:v>
                </c:pt>
                <c:pt idx="25">
                  <c:v>0.52500000000000002</c:v>
                </c:pt>
              </c:numCache>
            </c:numRef>
          </c:xVal>
          <c:yVal>
            <c:numRef>
              <c:f>全体!$AH$2:$AH$27</c:f>
              <c:numCache>
                <c:formatCode>General</c:formatCode>
                <c:ptCount val="26"/>
                <c:pt idx="0">
                  <c:v>2.6</c:v>
                </c:pt>
                <c:pt idx="1">
                  <c:v>2.9</c:v>
                </c:pt>
                <c:pt idx="2">
                  <c:v>1.3</c:v>
                </c:pt>
                <c:pt idx="3">
                  <c:v>1.5</c:v>
                </c:pt>
                <c:pt idx="4">
                  <c:v>2.7</c:v>
                </c:pt>
                <c:pt idx="5">
                  <c:v>1.7</c:v>
                </c:pt>
                <c:pt idx="6">
                  <c:v>2</c:v>
                </c:pt>
                <c:pt idx="7">
                  <c:v>2.4</c:v>
                </c:pt>
                <c:pt idx="8">
                  <c:v>2.7</c:v>
                </c:pt>
                <c:pt idx="9">
                  <c:v>2</c:v>
                </c:pt>
                <c:pt idx="10">
                  <c:v>4.9000000000000004</c:v>
                </c:pt>
                <c:pt idx="11">
                  <c:v>3.4</c:v>
                </c:pt>
                <c:pt idx="12">
                  <c:v>1.6</c:v>
                </c:pt>
                <c:pt idx="13">
                  <c:v>2.2999999999999998</c:v>
                </c:pt>
                <c:pt idx="14">
                  <c:v>2.9</c:v>
                </c:pt>
                <c:pt idx="15">
                  <c:v>2.5</c:v>
                </c:pt>
                <c:pt idx="16">
                  <c:v>2.5</c:v>
                </c:pt>
                <c:pt idx="17">
                  <c:v>1.5</c:v>
                </c:pt>
                <c:pt idx="18">
                  <c:v>1.9</c:v>
                </c:pt>
                <c:pt idx="19">
                  <c:v>3</c:v>
                </c:pt>
                <c:pt idx="20">
                  <c:v>1.6</c:v>
                </c:pt>
                <c:pt idx="21">
                  <c:v>3.2</c:v>
                </c:pt>
                <c:pt idx="22">
                  <c:v>3.1</c:v>
                </c:pt>
                <c:pt idx="23">
                  <c:v>2.2000000000000002</c:v>
                </c:pt>
                <c:pt idx="24">
                  <c:v>1.7</c:v>
                </c:pt>
                <c:pt idx="25">
                  <c:v>1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4E5-4511-9AAB-E4D7B300A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8063488"/>
        <c:axId val="-2089267104"/>
      </c:scatterChart>
      <c:valAx>
        <c:axId val="2138063488"/>
        <c:scaling>
          <c:orientation val="minMax"/>
          <c:max val="0.75000000000000011"/>
          <c:min val="0.35000000000000003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089267104"/>
        <c:crosses val="autoZero"/>
        <c:crossBetween val="midCat"/>
        <c:majorUnit val="0.1"/>
      </c:valAx>
      <c:valAx>
        <c:axId val="-20892671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138063488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174559-18B8-4114-B2EA-E7459CC12A2B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5B188F-08BB-4133-B54B-02CA7CE7F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7709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data 7. Amino acids profile in obese children with decreased HOMA-IR and BMI after intervention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Valine, Leucine, Isoleucine, Alanine and Tyrosine were apt to decrease and Glycine significantly increased with decreased HOMA-IR and BMI after intervention (N = 7). (B) Valine and BCAA/TFAA significantly decreased and Serine and Glycine increased after intervention in obese children with HOMA-IR 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≧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.5 (N = 6). (C) Obese children with HOMA-IR &lt; 2.5 (N = 1)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FAA: Total free amino acids, EAA: Essential amino acids, NEAA: Non-essential amino acids, BCAA: Branched chain amino acids, Amino acids: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mol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mL, Mean 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±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D, *P &lt; 0.05, **P &lt; 0.01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0A81E3-40CE-8746-A169-36368CA1F4EA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6320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Valine, Leucine, Isoleucine, Alanine and Tyrosine increased and Serine and Fischer ratio decreased with increased HOMA-IR and decreased BMI after intervention (N = 14). Moreover, many amino acids including Phenylalanine, Tryptophan and Methionine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c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creased.  (B) Leucine, Isoleucine, Alanine and Glycine, TFAA and BCAA significantly increased with HOMA-IR after intervention in obese children with HOMA-IR &lt; 2.5 (N = 11). (C) Fischer ratio decreased with increased HOMA-IR after intervention in obese children with HOMA-IR 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≧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.5 (N = 3). 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FAA: Total free amino acids, EAA: Essential amino acids, NEAA: Non-essential amino acids, BCAA: Branched chain amino acids, Amino acids: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mol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mL, Mean 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±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D, *P &lt; 0.05, **P &lt; 0.01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0A81E3-40CE-8746-A169-36368CA1F4EA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65157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858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743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339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8453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090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01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395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810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758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448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1211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84E8A-EEBF-4780-84E6-602F4EA22593}" type="datetimeFigureOut">
              <a:rPr kumimoji="1" lang="ja-JP" altLang="en-US" smtClean="0"/>
              <a:t>2019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E799E-32AD-438A-AF0D-44ED6A4E63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0727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CB83FA2-2DC1-4205-B288-6E292359E4AD}"/>
              </a:ext>
            </a:extLst>
          </p:cNvPr>
          <p:cNvGrpSpPr/>
          <p:nvPr/>
        </p:nvGrpSpPr>
        <p:grpSpPr>
          <a:xfrm>
            <a:off x="661583" y="1326347"/>
            <a:ext cx="5472000" cy="7040687"/>
            <a:chOff x="908720" y="560223"/>
            <a:chExt cx="5472000" cy="7040687"/>
          </a:xfrm>
        </p:grpSpPr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B56AF562-65F7-4253-BC2A-2134EDA015F3}"/>
                </a:ext>
              </a:extLst>
            </p:cNvPr>
            <p:cNvCxnSpPr/>
            <p:nvPr/>
          </p:nvCxnSpPr>
          <p:spPr>
            <a:xfrm flipH="1">
              <a:off x="908720" y="7567684"/>
              <a:ext cx="54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F99C9EFF-A68C-4944-8565-AEBDAAF02F6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08720" y="1121993"/>
              <a:ext cx="54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59F98F79-597B-4FEA-89F9-A1E4EE6F5D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08720" y="571477"/>
              <a:ext cx="547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4EDFAC16-615D-48CA-BE79-209D38AFC928}"/>
                </a:ext>
              </a:extLst>
            </p:cNvPr>
            <p:cNvGrpSpPr/>
            <p:nvPr/>
          </p:nvGrpSpPr>
          <p:grpSpPr>
            <a:xfrm>
              <a:off x="1183098" y="1129825"/>
              <a:ext cx="1414458" cy="6470539"/>
              <a:chOff x="1791716" y="1129825"/>
              <a:chExt cx="709942" cy="6276542"/>
            </a:xfrm>
          </p:grpSpPr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D54405D1-7199-4F49-A285-E6B7AC060386}"/>
                  </a:ext>
                </a:extLst>
              </p:cNvPr>
              <p:cNvSpPr txBox="1"/>
              <p:nvPr/>
            </p:nvSpPr>
            <p:spPr>
              <a:xfrm>
                <a:off x="2117638" y="1400195"/>
                <a:ext cx="287396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MI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E163ACAE-9750-4096-A674-05EAF69ED5D6}"/>
                  </a:ext>
                </a:extLst>
              </p:cNvPr>
              <p:cNvSpPr txBox="1"/>
              <p:nvPr/>
            </p:nvSpPr>
            <p:spPr>
              <a:xfrm>
                <a:off x="2008023" y="3292785"/>
                <a:ext cx="397011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-CHO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276A950B-BB50-4464-8175-875537A56798}"/>
                  </a:ext>
                </a:extLst>
              </p:cNvPr>
              <p:cNvSpPr txBox="1"/>
              <p:nvPr/>
            </p:nvSpPr>
            <p:spPr>
              <a:xfrm>
                <a:off x="2175568" y="3563155"/>
                <a:ext cx="229466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G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04E18EBD-87FE-4B80-A185-107646736801}"/>
                  </a:ext>
                </a:extLst>
              </p:cNvPr>
              <p:cNvSpPr txBox="1"/>
              <p:nvPr/>
            </p:nvSpPr>
            <p:spPr>
              <a:xfrm>
                <a:off x="1843434" y="3833525"/>
                <a:ext cx="657500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DL-CHO**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FD21190A-E36C-4BB5-97E1-A90703093E2A}"/>
                  </a:ext>
                </a:extLst>
              </p:cNvPr>
              <p:cNvSpPr txBox="1"/>
              <p:nvPr/>
            </p:nvSpPr>
            <p:spPr>
              <a:xfrm>
                <a:off x="1861784" y="4103895"/>
                <a:ext cx="543250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DL-CHO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92488B18-C5F6-470D-874F-1EC7E47D7C2C}"/>
                  </a:ext>
                </a:extLst>
              </p:cNvPr>
              <p:cNvSpPr txBox="1"/>
              <p:nvPr/>
            </p:nvSpPr>
            <p:spPr>
              <a:xfrm>
                <a:off x="2107179" y="3022415"/>
                <a:ext cx="297855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HE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22532ED9-6C52-4E8A-96DB-08C4D3ACE884}"/>
                  </a:ext>
                </a:extLst>
              </p:cNvPr>
              <p:cNvSpPr txBox="1"/>
              <p:nvPr/>
            </p:nvSpPr>
            <p:spPr>
              <a:xfrm>
                <a:off x="1911841" y="4644635"/>
                <a:ext cx="561693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 A-I**</a:t>
                </a:r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5ACAF8D4-2F0D-413C-BC42-9A217DDF973D}"/>
                  </a:ext>
                </a:extLst>
              </p:cNvPr>
              <p:cNvSpPr txBox="1"/>
              <p:nvPr/>
            </p:nvSpPr>
            <p:spPr>
              <a:xfrm>
                <a:off x="1930391" y="4915005"/>
                <a:ext cx="570543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A-II**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AA327E95-D5AD-4FF1-98F4-9EF3BAFC6DC1}"/>
                  </a:ext>
                </a:extLst>
              </p:cNvPr>
              <p:cNvSpPr txBox="1"/>
              <p:nvPr/>
            </p:nvSpPr>
            <p:spPr>
              <a:xfrm>
                <a:off x="2037660" y="5185375"/>
                <a:ext cx="415324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B*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00222236-C8E2-4F46-87F9-FA4B6055EE80}"/>
                  </a:ext>
                </a:extLst>
              </p:cNvPr>
              <p:cNvSpPr txBox="1"/>
              <p:nvPr/>
            </p:nvSpPr>
            <p:spPr>
              <a:xfrm>
                <a:off x="1937413" y="5455745"/>
                <a:ext cx="467621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C-II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312E87BE-F972-45FC-A747-66134D3FFBC2}"/>
                  </a:ext>
                </a:extLst>
              </p:cNvPr>
              <p:cNvSpPr txBox="1"/>
              <p:nvPr/>
            </p:nvSpPr>
            <p:spPr>
              <a:xfrm>
                <a:off x="2046835" y="5996485"/>
                <a:ext cx="358199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E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CA79A7B3-C389-44EB-AEA9-A3C53CEB0C0D}"/>
                  </a:ext>
                </a:extLst>
              </p:cNvPr>
              <p:cNvSpPr txBox="1"/>
              <p:nvPr/>
            </p:nvSpPr>
            <p:spPr>
              <a:xfrm>
                <a:off x="2066145" y="6266855"/>
                <a:ext cx="338889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</a:t>
                </a:r>
                <a:r>
                  <a:rPr lang="en-US" altLang="ja-JP" sz="16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u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759D29A5-6F92-4D62-921A-BB573252DE46}"/>
                  </a:ext>
                </a:extLst>
              </p:cNvPr>
              <p:cNvSpPr txBox="1"/>
              <p:nvPr/>
            </p:nvSpPr>
            <p:spPr>
              <a:xfrm>
                <a:off x="1979250" y="6537225"/>
                <a:ext cx="425784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rtisol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7541B833-A5EA-4CCD-891F-1E610B19E543}"/>
                  </a:ext>
                </a:extLst>
              </p:cNvPr>
              <p:cNvSpPr txBox="1"/>
              <p:nvPr/>
            </p:nvSpPr>
            <p:spPr>
              <a:xfrm>
                <a:off x="2025112" y="6807595"/>
                <a:ext cx="379922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sulin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5DD7700E-2424-47BC-9007-5FEDE44F29FD}"/>
                  </a:ext>
                </a:extLst>
              </p:cNvPr>
              <p:cNvSpPr txBox="1"/>
              <p:nvPr/>
            </p:nvSpPr>
            <p:spPr>
              <a:xfrm>
                <a:off x="1860978" y="7077963"/>
                <a:ext cx="544056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MA-IR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08594B96-1216-4A8A-9F64-B45B276B9A34}"/>
                  </a:ext>
                </a:extLst>
              </p:cNvPr>
              <p:cNvSpPr txBox="1"/>
              <p:nvPr/>
            </p:nvSpPr>
            <p:spPr>
              <a:xfrm>
                <a:off x="1902816" y="5726115"/>
                <a:ext cx="502218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o C-III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E959C20A-5119-42FA-A9A6-DE7EB1696B74}"/>
                  </a:ext>
                </a:extLst>
              </p:cNvPr>
              <p:cNvSpPr txBox="1"/>
              <p:nvPr/>
            </p:nvSpPr>
            <p:spPr>
              <a:xfrm>
                <a:off x="2164304" y="1670565"/>
                <a:ext cx="240730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A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id="{903A77B1-AB4A-4D66-A395-2D26CB1895FC}"/>
                  </a:ext>
                </a:extLst>
              </p:cNvPr>
              <p:cNvSpPr txBox="1"/>
              <p:nvPr/>
            </p:nvSpPr>
            <p:spPr>
              <a:xfrm>
                <a:off x="2118443" y="1940935"/>
                <a:ext cx="286591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ST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E3B87A29-4D76-4FA0-8EDB-1C3BC88EF6A2}"/>
                  </a:ext>
                </a:extLst>
              </p:cNvPr>
              <p:cNvSpPr txBox="1"/>
              <p:nvPr/>
            </p:nvSpPr>
            <p:spPr>
              <a:xfrm>
                <a:off x="2101547" y="2481675"/>
                <a:ext cx="303487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DH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875C23FB-4CA5-4E87-8A66-A18A2B62E13A}"/>
                  </a:ext>
                </a:extLst>
              </p:cNvPr>
              <p:cNvSpPr txBox="1"/>
              <p:nvPr/>
            </p:nvSpPr>
            <p:spPr>
              <a:xfrm>
                <a:off x="2122272" y="2211305"/>
                <a:ext cx="282762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T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9D2608CD-B388-4D5F-8050-06FA407ABD02}"/>
                  </a:ext>
                </a:extLst>
              </p:cNvPr>
              <p:cNvSpPr txBox="1"/>
              <p:nvPr/>
            </p:nvSpPr>
            <p:spPr>
              <a:xfrm>
                <a:off x="2037985" y="2752045"/>
                <a:ext cx="367049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-GTP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id="{91A84EBF-A15C-49AA-B1C0-D434B4698404}"/>
                  </a:ext>
                </a:extLst>
              </p:cNvPr>
              <p:cNvSpPr txBox="1"/>
              <p:nvPr/>
            </p:nvSpPr>
            <p:spPr>
              <a:xfrm>
                <a:off x="1819021" y="4374265"/>
                <a:ext cx="682637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DL / HDL**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05DBE6B1-767C-4C8D-9DB5-0B8133845501}"/>
                  </a:ext>
                </a:extLst>
              </p:cNvPr>
              <p:cNvSpPr txBox="1"/>
              <p:nvPr/>
            </p:nvSpPr>
            <p:spPr>
              <a:xfrm>
                <a:off x="1791716" y="1129825"/>
                <a:ext cx="661268" cy="32840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T (Mean)*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CCE25DC5-E3EC-44E1-B672-D59120EC1FA3}"/>
                </a:ext>
              </a:extLst>
            </p:cNvPr>
            <p:cNvGrpSpPr/>
            <p:nvPr/>
          </p:nvGrpSpPr>
          <p:grpSpPr>
            <a:xfrm>
              <a:off x="2704711" y="560223"/>
              <a:ext cx="1669815" cy="7040687"/>
              <a:chOff x="3123863" y="560533"/>
              <a:chExt cx="831510" cy="6846654"/>
            </a:xfrm>
          </p:grpSpPr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C02B67B9-9B83-4F1B-8B3D-37637BDD1F97}"/>
                  </a:ext>
                </a:extLst>
              </p:cNvPr>
              <p:cNvSpPr txBox="1"/>
              <p:nvPr/>
            </p:nvSpPr>
            <p:spPr>
              <a:xfrm>
                <a:off x="3123863" y="560533"/>
                <a:ext cx="831510" cy="5686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DL / HDL ≤</a:t>
                </a:r>
                <a:r>
                  <a:rPr lang="ja-JP" altLang="en-US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 </a:t>
                </a:r>
              </a:p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=11)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90533CC1-97AA-49A3-BBD5-F30DB02B90AD}"/>
                  </a:ext>
                </a:extLst>
              </p:cNvPr>
              <p:cNvSpPr txBox="1"/>
              <p:nvPr/>
            </p:nvSpPr>
            <p:spPr>
              <a:xfrm>
                <a:off x="3154775" y="3292785"/>
                <a:ext cx="756093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2.91 ± 30.76</a:t>
                </a: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4D6692D1-EA64-4ECD-BFE9-AA2208917AB9}"/>
                  </a:ext>
                </a:extLst>
              </p:cNvPr>
              <p:cNvSpPr txBox="1"/>
              <p:nvPr/>
            </p:nvSpPr>
            <p:spPr>
              <a:xfrm>
                <a:off x="3154775" y="3022415"/>
                <a:ext cx="756093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2.36 ± 98.75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6AD4DF95-50C0-4406-99D8-74E74540B207}"/>
                  </a:ext>
                </a:extLst>
              </p:cNvPr>
              <p:cNvSpPr txBox="1"/>
              <p:nvPr/>
            </p:nvSpPr>
            <p:spPr>
              <a:xfrm>
                <a:off x="3211079" y="3563155"/>
                <a:ext cx="7050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.18 ± 42.30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8CF89407-F861-4C17-B103-CEC8F27F248A}"/>
                  </a:ext>
                </a:extLst>
              </p:cNvPr>
              <p:cNvSpPr txBox="1"/>
              <p:nvPr/>
            </p:nvSpPr>
            <p:spPr>
              <a:xfrm>
                <a:off x="3210275" y="3833525"/>
                <a:ext cx="7050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8.55 ± 14.93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6CBA0392-186F-4E5E-95EF-EB7A133A7874}"/>
                  </a:ext>
                </a:extLst>
              </p:cNvPr>
              <p:cNvSpPr txBox="1"/>
              <p:nvPr/>
            </p:nvSpPr>
            <p:spPr>
              <a:xfrm>
                <a:off x="3166758" y="4103895"/>
                <a:ext cx="756093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1.82 ± 19.4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34CBB598-5973-45DE-A07B-101C95516CC0}"/>
                  </a:ext>
                </a:extLst>
              </p:cNvPr>
              <p:cNvSpPr txBox="1"/>
              <p:nvPr/>
            </p:nvSpPr>
            <p:spPr>
              <a:xfrm>
                <a:off x="3166758" y="4644635"/>
                <a:ext cx="756093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6.67 ± 18.25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1E8A022E-1ECD-4BE3-B42A-3E40670CB1A5}"/>
                  </a:ext>
                </a:extLst>
              </p:cNvPr>
              <p:cNvSpPr txBox="1"/>
              <p:nvPr/>
            </p:nvSpPr>
            <p:spPr>
              <a:xfrm>
                <a:off x="3217043" y="4915005"/>
                <a:ext cx="65391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.22 ± 5.4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FD845AFE-9194-43B9-A0C8-02CAB44007EF}"/>
                  </a:ext>
                </a:extLst>
              </p:cNvPr>
              <p:cNvSpPr txBox="1"/>
              <p:nvPr/>
            </p:nvSpPr>
            <p:spPr>
              <a:xfrm>
                <a:off x="3218171" y="5185375"/>
                <a:ext cx="7012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.33 ± 11.78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42F8FCC0-5903-45C3-B78F-A104F2671831}"/>
                  </a:ext>
                </a:extLst>
              </p:cNvPr>
              <p:cNvSpPr txBox="1"/>
              <p:nvPr/>
            </p:nvSpPr>
            <p:spPr>
              <a:xfrm>
                <a:off x="3273350" y="5726115"/>
                <a:ext cx="602832" cy="3292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98 ± 2.2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529E65F4-E700-477F-8BD7-B7C9F5DCFDBB}"/>
                  </a:ext>
                </a:extLst>
              </p:cNvPr>
              <p:cNvSpPr txBox="1"/>
              <p:nvPr/>
            </p:nvSpPr>
            <p:spPr>
              <a:xfrm>
                <a:off x="3273351" y="5996485"/>
                <a:ext cx="60283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12 ± 1.47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B7E85500-E60B-4F57-96C4-F84D5A6F4BA6}"/>
                  </a:ext>
                </a:extLst>
              </p:cNvPr>
              <p:cNvSpPr txBox="1"/>
              <p:nvPr/>
            </p:nvSpPr>
            <p:spPr>
              <a:xfrm>
                <a:off x="3229831" y="6266855"/>
                <a:ext cx="65391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.30 ± 8.63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A20DE46F-17CA-4154-BB6E-6567A0C0554C}"/>
                  </a:ext>
                </a:extLst>
              </p:cNvPr>
              <p:cNvSpPr txBox="1"/>
              <p:nvPr/>
            </p:nvSpPr>
            <p:spPr>
              <a:xfrm>
                <a:off x="3236627" y="6537225"/>
                <a:ext cx="65391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.00 ± 6.5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FF9CDA88-2A15-48CA-AEB6-C9B760545779}"/>
                  </a:ext>
                </a:extLst>
              </p:cNvPr>
              <p:cNvSpPr txBox="1"/>
              <p:nvPr/>
            </p:nvSpPr>
            <p:spPr>
              <a:xfrm>
                <a:off x="3235046" y="6807595"/>
                <a:ext cx="7050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.23 ± 10.36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40C7B9C4-8DB8-4C76-AB19-3E9C4FD83813}"/>
                  </a:ext>
                </a:extLst>
              </p:cNvPr>
              <p:cNvSpPr txBox="1"/>
              <p:nvPr/>
            </p:nvSpPr>
            <p:spPr>
              <a:xfrm>
                <a:off x="3285341" y="7077963"/>
                <a:ext cx="628375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74 ± 2.77 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6A37F2E0-AB89-4489-A88A-DBB8A659D44F}"/>
                  </a:ext>
                </a:extLst>
              </p:cNvPr>
              <p:cNvSpPr txBox="1"/>
              <p:nvPr/>
            </p:nvSpPr>
            <p:spPr>
              <a:xfrm>
                <a:off x="3267358" y="5455745"/>
                <a:ext cx="60283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14 ± 1.07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FEDAEC6B-574E-4BDB-8855-77F1A0C456F1}"/>
                  </a:ext>
                </a:extLst>
              </p:cNvPr>
              <p:cNvSpPr txBox="1"/>
              <p:nvPr/>
            </p:nvSpPr>
            <p:spPr>
              <a:xfrm>
                <a:off x="3244194" y="1670565"/>
                <a:ext cx="60283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2 ± 0.99</a:t>
                </a: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45991172-E83A-47A0-B401-D89C864AF0CD}"/>
                  </a:ext>
                </a:extLst>
              </p:cNvPr>
              <p:cNvSpPr txBox="1"/>
              <p:nvPr/>
            </p:nvSpPr>
            <p:spPr>
              <a:xfrm>
                <a:off x="3194681" y="1400195"/>
                <a:ext cx="65391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.40 ± 2.21</a:t>
                </a: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ADA05FCF-B8EB-43D8-A7DC-39CEB1F3EC21}"/>
                  </a:ext>
                </a:extLst>
              </p:cNvPr>
              <p:cNvSpPr txBox="1"/>
              <p:nvPr/>
            </p:nvSpPr>
            <p:spPr>
              <a:xfrm>
                <a:off x="3193107" y="1940935"/>
                <a:ext cx="7050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.27 ± 10.75</a:t>
                </a: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8A7FB48B-52FA-4E79-9152-3247CBB862E5}"/>
                  </a:ext>
                </a:extLst>
              </p:cNvPr>
              <p:cNvSpPr txBox="1"/>
              <p:nvPr/>
            </p:nvSpPr>
            <p:spPr>
              <a:xfrm>
                <a:off x="3193107" y="2211305"/>
                <a:ext cx="7050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7.91 ± 24.19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DC25D07D-8E65-498C-8CE7-B943F3448122}"/>
                  </a:ext>
                </a:extLst>
              </p:cNvPr>
              <p:cNvSpPr txBox="1"/>
              <p:nvPr/>
            </p:nvSpPr>
            <p:spPr>
              <a:xfrm>
                <a:off x="3149589" y="2481675"/>
                <a:ext cx="756093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1.55 ± 21.5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2685E524-9819-4681-909C-78DC5A285F98}"/>
                  </a:ext>
                </a:extLst>
              </p:cNvPr>
              <p:cNvSpPr txBox="1"/>
              <p:nvPr/>
            </p:nvSpPr>
            <p:spPr>
              <a:xfrm>
                <a:off x="3206991" y="2752045"/>
                <a:ext cx="70120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.09 ± 11.19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D8D54812-7558-449F-A6B7-D65CE98A7F6D}"/>
                  </a:ext>
                </a:extLst>
              </p:cNvPr>
              <p:cNvSpPr txBox="1"/>
              <p:nvPr/>
            </p:nvSpPr>
            <p:spPr>
              <a:xfrm>
                <a:off x="3266554" y="4374265"/>
                <a:ext cx="60283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70 ± 0.23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A13F9D5A-0E7C-4729-B8E2-359818F8CCA7}"/>
                  </a:ext>
                </a:extLst>
              </p:cNvPr>
              <p:cNvSpPr txBox="1"/>
              <p:nvPr/>
            </p:nvSpPr>
            <p:spPr>
              <a:xfrm>
                <a:off x="3238204" y="1129825"/>
                <a:ext cx="60283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1 ± 0.06</a:t>
                </a:r>
              </a:p>
            </p:txBody>
          </p: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0691B321-7062-461D-AD8C-881D70CB1F06}"/>
                </a:ext>
              </a:extLst>
            </p:cNvPr>
            <p:cNvGrpSpPr/>
            <p:nvPr/>
          </p:nvGrpSpPr>
          <p:grpSpPr>
            <a:xfrm>
              <a:off x="4646928" y="571477"/>
              <a:ext cx="1621727" cy="7029433"/>
              <a:chOff x="5053394" y="571477"/>
              <a:chExt cx="808778" cy="6835710"/>
            </a:xfrm>
          </p:grpSpPr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C6A1D8A2-36D0-4BC3-90D1-6F76A48C6A06}"/>
                  </a:ext>
                </a:extLst>
              </p:cNvPr>
              <p:cNvSpPr txBox="1"/>
              <p:nvPr/>
            </p:nvSpPr>
            <p:spPr>
              <a:xfrm>
                <a:off x="5065556" y="329278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16.33 ± 31.08</a:t>
                </a: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14B34706-A0A4-4F18-968E-709F89EF5B3F}"/>
                  </a:ext>
                </a:extLst>
              </p:cNvPr>
              <p:cNvSpPr txBox="1"/>
              <p:nvPr/>
            </p:nvSpPr>
            <p:spPr>
              <a:xfrm>
                <a:off x="5065556" y="302241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73.67 ± 55.88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E3892523-8215-4266-B521-9CF86C2EB5DD}"/>
                  </a:ext>
                </a:extLst>
              </p:cNvPr>
              <p:cNvSpPr txBox="1"/>
              <p:nvPr/>
            </p:nvSpPr>
            <p:spPr>
              <a:xfrm>
                <a:off x="5072363" y="356315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9.87 ± 70.56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59A50428-681B-4971-9EAD-DA127F2C1B59}"/>
                  </a:ext>
                </a:extLst>
              </p:cNvPr>
              <p:cNvSpPr txBox="1"/>
              <p:nvPr/>
            </p:nvSpPr>
            <p:spPr>
              <a:xfrm>
                <a:off x="5130332" y="3833525"/>
                <a:ext cx="65490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2.73 ± 9.66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8BD6283D-49BA-495F-9897-D9733605997D}"/>
                  </a:ext>
                </a:extLst>
              </p:cNvPr>
              <p:cNvSpPr txBox="1"/>
              <p:nvPr/>
            </p:nvSpPr>
            <p:spPr>
              <a:xfrm>
                <a:off x="5079168" y="410389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9.00 ± 24.38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0B955B2C-D81B-4945-82DD-54790B1C0818}"/>
                  </a:ext>
                </a:extLst>
              </p:cNvPr>
              <p:cNvSpPr txBox="1"/>
              <p:nvPr/>
            </p:nvSpPr>
            <p:spPr>
              <a:xfrm>
                <a:off x="5079168" y="464463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6.30 ± 18.03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278C4284-2799-4C4C-98B4-75BBAB195307}"/>
                  </a:ext>
                </a:extLst>
              </p:cNvPr>
              <p:cNvSpPr txBox="1"/>
              <p:nvPr/>
            </p:nvSpPr>
            <p:spPr>
              <a:xfrm>
                <a:off x="5130333" y="4915005"/>
                <a:ext cx="65490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1.37 ± 4.62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CF4F6ADB-3AE4-4E27-8A0F-BDE87B8DEC18}"/>
                  </a:ext>
                </a:extLst>
              </p:cNvPr>
              <p:cNvSpPr txBox="1"/>
              <p:nvPr/>
            </p:nvSpPr>
            <p:spPr>
              <a:xfrm>
                <a:off x="5081072" y="5185375"/>
                <a:ext cx="753425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2.10 ± 19.58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E8B0BAED-D572-43A7-8529-67CE2D03A780}"/>
                  </a:ext>
                </a:extLst>
              </p:cNvPr>
              <p:cNvSpPr txBox="1"/>
              <p:nvPr/>
            </p:nvSpPr>
            <p:spPr>
              <a:xfrm>
                <a:off x="5189945" y="572611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.62 ± 2.36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0C6B72A7-00BB-4D02-8445-7FBDA22E1856}"/>
                  </a:ext>
                </a:extLst>
              </p:cNvPr>
              <p:cNvSpPr txBox="1"/>
              <p:nvPr/>
            </p:nvSpPr>
            <p:spPr>
              <a:xfrm>
                <a:off x="5183140" y="599648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89 ± 1.00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81C283EA-6D1F-4B23-8F4C-DA66C22E53E2}"/>
                  </a:ext>
                </a:extLst>
              </p:cNvPr>
              <p:cNvSpPr txBox="1"/>
              <p:nvPr/>
            </p:nvSpPr>
            <p:spPr>
              <a:xfrm>
                <a:off x="5132236" y="6266855"/>
                <a:ext cx="65109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1.80 ± 6.11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6D339380-01A0-4FA0-BDDF-C7C18AC59B07}"/>
                  </a:ext>
                </a:extLst>
              </p:cNvPr>
              <p:cNvSpPr txBox="1"/>
              <p:nvPr/>
            </p:nvSpPr>
            <p:spPr>
              <a:xfrm>
                <a:off x="5189946" y="653722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52 ± 4.58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CF845B10-F8F4-4CAF-9BF3-8D3B94E3BE5D}"/>
                  </a:ext>
                </a:extLst>
              </p:cNvPr>
              <p:cNvSpPr txBox="1"/>
              <p:nvPr/>
            </p:nvSpPr>
            <p:spPr>
              <a:xfrm>
                <a:off x="5139042" y="6807595"/>
                <a:ext cx="651096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.05 ± 6.22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5686E95B-9069-414D-8E25-BB6464FD4BEC}"/>
                  </a:ext>
                </a:extLst>
              </p:cNvPr>
              <p:cNvSpPr txBox="1"/>
              <p:nvPr/>
            </p:nvSpPr>
            <p:spPr>
              <a:xfrm>
                <a:off x="5189946" y="7077963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1 ± 1.4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FA9CFA99-CFA8-4A8F-B989-EE64651A4973}"/>
                  </a:ext>
                </a:extLst>
              </p:cNvPr>
              <p:cNvSpPr txBox="1"/>
              <p:nvPr/>
            </p:nvSpPr>
            <p:spPr>
              <a:xfrm>
                <a:off x="5189946" y="545574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.53 ± 1.17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3684F50B-4229-49E6-81F0-407203A475D1}"/>
                  </a:ext>
                </a:extLst>
              </p:cNvPr>
              <p:cNvSpPr txBox="1"/>
              <p:nvPr/>
            </p:nvSpPr>
            <p:spPr>
              <a:xfrm>
                <a:off x="5155914" y="167056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6 ± 1.18</a:t>
                </a: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67618195-4882-4F28-9ACF-90B0D96D1628}"/>
                  </a:ext>
                </a:extLst>
              </p:cNvPr>
              <p:cNvSpPr txBox="1"/>
              <p:nvPr/>
            </p:nvSpPr>
            <p:spPr>
              <a:xfrm>
                <a:off x="5053394" y="571477"/>
                <a:ext cx="808778" cy="5686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DL / HDL &gt;</a:t>
                </a:r>
                <a:r>
                  <a:rPr lang="ja-JP" altLang="en-US" sz="16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</a:p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N=15)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D70C873F-B5BA-4AA3-A5D3-587BA13F1717}"/>
                  </a:ext>
                </a:extLst>
              </p:cNvPr>
              <p:cNvSpPr txBox="1"/>
              <p:nvPr/>
            </p:nvSpPr>
            <p:spPr>
              <a:xfrm>
                <a:off x="5103106" y="1400195"/>
                <a:ext cx="65490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.40 ± 2.64</a:t>
                </a: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A2423FAD-34E2-4C41-A5B4-ABA9D8933165}"/>
                  </a:ext>
                </a:extLst>
              </p:cNvPr>
              <p:cNvSpPr txBox="1"/>
              <p:nvPr/>
            </p:nvSpPr>
            <p:spPr>
              <a:xfrm>
                <a:off x="5104750" y="1940935"/>
                <a:ext cx="706065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.67 ± 10.36</a:t>
                </a: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90286C24-73D5-47E4-B96C-5B0281C57706}"/>
                  </a:ext>
                </a:extLst>
              </p:cNvPr>
              <p:cNvSpPr txBox="1"/>
              <p:nvPr/>
            </p:nvSpPr>
            <p:spPr>
              <a:xfrm>
                <a:off x="5111557" y="2211305"/>
                <a:ext cx="706065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.00 ± 21.54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8A5F8C6E-9240-4805-A6C2-887AD1D87232}"/>
                  </a:ext>
                </a:extLst>
              </p:cNvPr>
              <p:cNvSpPr txBox="1"/>
              <p:nvPr/>
            </p:nvSpPr>
            <p:spPr>
              <a:xfrm>
                <a:off x="5065556" y="2481675"/>
                <a:ext cx="757229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70.93 ± 70.25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E84A0666-5111-4A93-A2E1-0415A9223638}"/>
                  </a:ext>
                </a:extLst>
              </p:cNvPr>
              <p:cNvSpPr txBox="1"/>
              <p:nvPr/>
            </p:nvSpPr>
            <p:spPr>
              <a:xfrm>
                <a:off x="5116721" y="2752045"/>
                <a:ext cx="654901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.20 ± 3.75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0424D202-ED25-458D-9FA4-BBACF96A7E2C}"/>
                  </a:ext>
                </a:extLst>
              </p:cNvPr>
              <p:cNvSpPr txBox="1"/>
              <p:nvPr/>
            </p:nvSpPr>
            <p:spPr>
              <a:xfrm>
                <a:off x="5183140" y="437426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89 ± 0.65</a:t>
                </a:r>
                <a:endPara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A7C01D2C-94ED-4167-8FB2-FF392997B705}"/>
                  </a:ext>
                </a:extLst>
              </p:cNvPr>
              <p:cNvSpPr txBox="1"/>
              <p:nvPr/>
            </p:nvSpPr>
            <p:spPr>
              <a:xfrm>
                <a:off x="5155914" y="1129825"/>
                <a:ext cx="603738" cy="3292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7 ± 0.05</a:t>
                </a:r>
              </a:p>
            </p:txBody>
          </p:sp>
        </p:grpSp>
      </p:grp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6EE2C766-A7D2-4834-A6E3-F0E984C78F07}"/>
              </a:ext>
            </a:extLst>
          </p:cNvPr>
          <p:cNvSpPr txBox="1"/>
          <p:nvPr/>
        </p:nvSpPr>
        <p:spPr>
          <a:xfrm>
            <a:off x="0" y="0"/>
            <a:ext cx="3111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1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D162444A-D046-40C1-93B9-C6A611A378AE}"/>
              </a:ext>
            </a:extLst>
          </p:cNvPr>
          <p:cNvSpPr txBox="1"/>
          <p:nvPr/>
        </p:nvSpPr>
        <p:spPr>
          <a:xfrm>
            <a:off x="0" y="1314618"/>
            <a:ext cx="484428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ja-JP" altLang="en-US" sz="2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328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A5C93C8-C044-49BA-B232-9DEB761BC856}"/>
              </a:ext>
            </a:extLst>
          </p:cNvPr>
          <p:cNvSpPr txBox="1"/>
          <p:nvPr/>
        </p:nvSpPr>
        <p:spPr>
          <a:xfrm>
            <a:off x="0" y="-113596"/>
            <a:ext cx="3111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1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7DB2DF57-DC90-495E-AF8C-187D72CE61BF}"/>
              </a:ext>
            </a:extLst>
          </p:cNvPr>
          <p:cNvGrpSpPr/>
          <p:nvPr/>
        </p:nvGrpSpPr>
        <p:grpSpPr>
          <a:xfrm>
            <a:off x="695864" y="431217"/>
            <a:ext cx="6120000" cy="9505560"/>
            <a:chOff x="695864" y="431217"/>
            <a:chExt cx="6120000" cy="9505560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F2C542A1-0A89-4415-889E-320D8394BDB2}"/>
                </a:ext>
              </a:extLst>
            </p:cNvPr>
            <p:cNvCxnSpPr/>
            <p:nvPr/>
          </p:nvCxnSpPr>
          <p:spPr>
            <a:xfrm flipH="1">
              <a:off x="695864" y="9918032"/>
              <a:ext cx="612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CD0F8FE4-2969-4E2B-806E-7D0323E57B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5864" y="982511"/>
              <a:ext cx="612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8C4869C8-09E3-4744-B045-DE96A96477C6}"/>
                </a:ext>
              </a:extLst>
            </p:cNvPr>
            <p:cNvCxnSpPr/>
            <p:nvPr/>
          </p:nvCxnSpPr>
          <p:spPr>
            <a:xfrm flipH="1">
              <a:off x="695864" y="459291"/>
              <a:ext cx="612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0622B2A7-4EE1-4C2E-B900-969B57B864BB}"/>
                </a:ext>
              </a:extLst>
            </p:cNvPr>
            <p:cNvSpPr txBox="1"/>
            <p:nvPr/>
          </p:nvSpPr>
          <p:spPr>
            <a:xfrm>
              <a:off x="1919555" y="1445871"/>
              <a:ext cx="7364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CE6310E2-9A5C-4E63-A66E-C666008A4206}"/>
                </a:ext>
              </a:extLst>
            </p:cNvPr>
            <p:cNvSpPr txBox="1"/>
            <p:nvPr/>
          </p:nvSpPr>
          <p:spPr>
            <a:xfrm>
              <a:off x="1775670" y="1700632"/>
              <a:ext cx="8803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uc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2188B07-221E-43AD-8DA7-9190C07DDDFF}"/>
                </a:ext>
              </a:extLst>
            </p:cNvPr>
            <p:cNvSpPr txBox="1"/>
            <p:nvPr/>
          </p:nvSpPr>
          <p:spPr>
            <a:xfrm>
              <a:off x="1591324" y="1955393"/>
              <a:ext cx="10647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leuc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2C94CE6-0A0F-42BD-A507-3AE3410A6B1C}"/>
                </a:ext>
              </a:extLst>
            </p:cNvPr>
            <p:cNvSpPr txBox="1"/>
            <p:nvPr/>
          </p:nvSpPr>
          <p:spPr>
            <a:xfrm>
              <a:off x="1716359" y="2210154"/>
              <a:ext cx="9396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stid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4F084A1-E166-4CFF-9FB9-A8B4DF6D69EE}"/>
                </a:ext>
              </a:extLst>
            </p:cNvPr>
            <p:cNvSpPr txBox="1"/>
            <p:nvPr/>
          </p:nvSpPr>
          <p:spPr>
            <a:xfrm>
              <a:off x="1305990" y="2464915"/>
              <a:ext cx="13500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enylalan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0CD4EB9F-20FE-40E4-A33C-2AE9D0453B8A}"/>
                </a:ext>
              </a:extLst>
            </p:cNvPr>
            <p:cNvSpPr txBox="1"/>
            <p:nvPr/>
          </p:nvSpPr>
          <p:spPr>
            <a:xfrm>
              <a:off x="1520024" y="2719677"/>
              <a:ext cx="11360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yptophan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82C06309-7664-4148-9266-7B9685871021}"/>
                </a:ext>
              </a:extLst>
            </p:cNvPr>
            <p:cNvSpPr txBox="1"/>
            <p:nvPr/>
          </p:nvSpPr>
          <p:spPr>
            <a:xfrm>
              <a:off x="1522396" y="2974438"/>
              <a:ext cx="11336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ion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3CE3D978-7974-4D1E-BA82-B5D4EC552396}"/>
                </a:ext>
              </a:extLst>
            </p:cNvPr>
            <p:cNvSpPr txBox="1"/>
            <p:nvPr/>
          </p:nvSpPr>
          <p:spPr>
            <a:xfrm>
              <a:off x="1626590" y="3229199"/>
              <a:ext cx="102944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on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754D0D63-E6C6-4226-8510-7BFF219F5701}"/>
                </a:ext>
              </a:extLst>
            </p:cNvPr>
            <p:cNvSpPr txBox="1"/>
            <p:nvPr/>
          </p:nvSpPr>
          <p:spPr>
            <a:xfrm>
              <a:off x="1900832" y="3483960"/>
              <a:ext cx="7552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ys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CC31A8A-B93E-4D9B-8DE4-16DE2640A61B}"/>
                </a:ext>
              </a:extLst>
            </p:cNvPr>
            <p:cNvSpPr txBox="1"/>
            <p:nvPr/>
          </p:nvSpPr>
          <p:spPr>
            <a:xfrm>
              <a:off x="1945588" y="3993481"/>
              <a:ext cx="7104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r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8132B7B0-0334-4FA9-A3BA-A62C725A41B8}"/>
                </a:ext>
              </a:extLst>
            </p:cNvPr>
            <p:cNvSpPr txBox="1"/>
            <p:nvPr/>
          </p:nvSpPr>
          <p:spPr>
            <a:xfrm>
              <a:off x="1796509" y="4248242"/>
              <a:ext cx="8595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220EBFCA-FFD5-42E9-AC81-7D84DAEB93CB}"/>
                </a:ext>
              </a:extLst>
            </p:cNvPr>
            <p:cNvSpPr txBox="1"/>
            <p:nvPr/>
          </p:nvSpPr>
          <p:spPr>
            <a:xfrm>
              <a:off x="1820555" y="4503003"/>
              <a:ext cx="8354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an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CB34B59F-DB91-4FE2-A743-88357EE0C5D8}"/>
                </a:ext>
              </a:extLst>
            </p:cNvPr>
            <p:cNvSpPr txBox="1"/>
            <p:nvPr/>
          </p:nvSpPr>
          <p:spPr>
            <a:xfrm>
              <a:off x="1754703" y="4757764"/>
              <a:ext cx="9013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yros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CCF84940-CD6E-4B6E-9596-00D81245DF3F}"/>
                </a:ext>
              </a:extLst>
            </p:cNvPr>
            <p:cNvSpPr txBox="1"/>
            <p:nvPr/>
          </p:nvSpPr>
          <p:spPr>
            <a:xfrm>
              <a:off x="1613766" y="5012526"/>
              <a:ext cx="10422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tamat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110EA03-7D07-47AE-9148-E6F31423552A}"/>
                </a:ext>
              </a:extLst>
            </p:cNvPr>
            <p:cNvSpPr txBox="1"/>
            <p:nvPr/>
          </p:nvSpPr>
          <p:spPr>
            <a:xfrm>
              <a:off x="1876658" y="5267287"/>
              <a:ext cx="7793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l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9BBCD10-65FB-4BC3-87E9-6E9AD912D938}"/>
                </a:ext>
              </a:extLst>
            </p:cNvPr>
            <p:cNvSpPr txBox="1"/>
            <p:nvPr/>
          </p:nvSpPr>
          <p:spPr>
            <a:xfrm>
              <a:off x="1602546" y="5522048"/>
              <a:ext cx="10534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tam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CF77D84-1032-4F75-BF85-FD79BC1FF916}"/>
                </a:ext>
              </a:extLst>
            </p:cNvPr>
            <p:cNvSpPr txBox="1"/>
            <p:nvPr/>
          </p:nvSpPr>
          <p:spPr>
            <a:xfrm>
              <a:off x="1681093" y="5776809"/>
              <a:ext cx="9749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itrull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2575E855-D8F1-4407-BFAF-C0B782BD2966}"/>
                </a:ext>
              </a:extLst>
            </p:cNvPr>
            <p:cNvSpPr txBox="1"/>
            <p:nvPr/>
          </p:nvSpPr>
          <p:spPr>
            <a:xfrm>
              <a:off x="1744124" y="6031570"/>
              <a:ext cx="9119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Argin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24118D0-7DAD-464C-B8D3-0BA7D5C87B9B}"/>
                </a:ext>
              </a:extLst>
            </p:cNvPr>
            <p:cNvSpPr txBox="1"/>
            <p:nvPr/>
          </p:nvSpPr>
          <p:spPr>
            <a:xfrm>
              <a:off x="1682697" y="6286330"/>
              <a:ext cx="9733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nith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74F90D68-CBAD-4F14-9E6A-E0B4E48996DC}"/>
                </a:ext>
              </a:extLst>
            </p:cNvPr>
            <p:cNvSpPr txBox="1"/>
            <p:nvPr/>
          </p:nvSpPr>
          <p:spPr>
            <a:xfrm>
              <a:off x="1535219" y="6541091"/>
              <a:ext cx="11208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parag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A9BAE46F-7920-4CDC-8630-61AD283A1B41}"/>
                </a:ext>
              </a:extLst>
            </p:cNvPr>
            <p:cNvSpPr txBox="1"/>
            <p:nvPr/>
          </p:nvSpPr>
          <p:spPr>
            <a:xfrm>
              <a:off x="1846074" y="6795852"/>
              <a:ext cx="80996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>
                  <a:latin typeface="Times New Roman" panose="02020603050405020304" pitchFamily="18" charset="0"/>
                  <a:cs typeface="Times New Roman" panose="02020603050405020304" pitchFamily="18" charset="0"/>
                </a:rPr>
                <a:t>Taur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B2D8EB59-D572-4068-AF22-6E3EFD65DC36}"/>
                </a:ext>
              </a:extLst>
            </p:cNvPr>
            <p:cNvSpPr txBox="1"/>
            <p:nvPr/>
          </p:nvSpPr>
          <p:spPr>
            <a:xfrm>
              <a:off x="1842997" y="7050613"/>
              <a:ext cx="81304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st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1AF40857-6292-4BA8-8510-EF19157B3FA5}"/>
                </a:ext>
              </a:extLst>
            </p:cNvPr>
            <p:cNvSpPr txBox="1"/>
            <p:nvPr/>
          </p:nvSpPr>
          <p:spPr>
            <a:xfrm>
              <a:off x="1379729" y="3738721"/>
              <a:ext cx="12763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partic acid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E79C91F1-8E70-4980-9293-E2793C18D606}"/>
                </a:ext>
              </a:extLst>
            </p:cNvPr>
            <p:cNvSpPr txBox="1"/>
            <p:nvPr/>
          </p:nvSpPr>
          <p:spPr>
            <a:xfrm>
              <a:off x="1158514" y="7305375"/>
              <a:ext cx="14975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droxyprol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576E9627-A1C6-4374-A19C-B499331D190E}"/>
                </a:ext>
              </a:extLst>
            </p:cNvPr>
            <p:cNvSpPr txBox="1"/>
            <p:nvPr/>
          </p:nvSpPr>
          <p:spPr>
            <a:xfrm>
              <a:off x="871576" y="7560135"/>
              <a:ext cx="17844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noethanolamine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EA18BCF5-58DF-4CC8-A210-923E9299D016}"/>
                </a:ext>
              </a:extLst>
            </p:cNvPr>
            <p:cNvSpPr txBox="1"/>
            <p:nvPr/>
          </p:nvSpPr>
          <p:spPr>
            <a:xfrm>
              <a:off x="746542" y="7814896"/>
              <a:ext cx="190949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-Aminobutyric acid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8F69397-F9A7-4A6C-9455-1E2479CCAB73}"/>
                </a:ext>
              </a:extLst>
            </p:cNvPr>
            <p:cNvSpPr txBox="1"/>
            <p:nvPr/>
          </p:nvSpPr>
          <p:spPr>
            <a:xfrm>
              <a:off x="1882814" y="8069657"/>
              <a:ext cx="7732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ja-JP" alt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F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DA95960B-90B8-47B3-93E7-5E941BF3D5F8}"/>
                </a:ext>
              </a:extLst>
            </p:cNvPr>
            <p:cNvSpPr txBox="1"/>
            <p:nvPr/>
          </p:nvSpPr>
          <p:spPr>
            <a:xfrm>
              <a:off x="1892688" y="8324418"/>
              <a:ext cx="7633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71E6FEBA-8013-4101-A280-E78EC21BB156}"/>
                </a:ext>
              </a:extLst>
            </p:cNvPr>
            <p:cNvSpPr txBox="1"/>
            <p:nvPr/>
          </p:nvSpPr>
          <p:spPr>
            <a:xfrm>
              <a:off x="2040165" y="8579179"/>
              <a:ext cx="6158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D62D9E71-AC93-487B-B1B2-9B8CBAD2527D}"/>
                </a:ext>
              </a:extLst>
            </p:cNvPr>
            <p:cNvSpPr txBox="1"/>
            <p:nvPr/>
          </p:nvSpPr>
          <p:spPr>
            <a:xfrm>
              <a:off x="1892688" y="8833940"/>
              <a:ext cx="7633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90C76F4B-EB24-476C-A57E-1E77CA1DEDAE}"/>
                </a:ext>
              </a:extLst>
            </p:cNvPr>
            <p:cNvSpPr txBox="1"/>
            <p:nvPr/>
          </p:nvSpPr>
          <p:spPr>
            <a:xfrm>
              <a:off x="1312530" y="9088701"/>
              <a:ext cx="13435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A / NE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9F19663F-404B-41FA-BDF2-250247B19C72}"/>
                </a:ext>
              </a:extLst>
            </p:cNvPr>
            <p:cNvSpPr txBox="1"/>
            <p:nvPr/>
          </p:nvSpPr>
          <p:spPr>
            <a:xfrm>
              <a:off x="1247320" y="9343462"/>
              <a:ext cx="14087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AA / </a:t>
              </a:r>
              <a:r>
                <a:rPr lang="en-US" altLang="ja-JP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fAA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FF39B3CB-8C0A-4250-A4FC-38A1E1627804}"/>
                </a:ext>
              </a:extLst>
            </p:cNvPr>
            <p:cNvSpPr txBox="1"/>
            <p:nvPr/>
          </p:nvSpPr>
          <p:spPr>
            <a:xfrm>
              <a:off x="1435833" y="9598223"/>
              <a:ext cx="12202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scher ratio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AB0BF04-0C27-4C17-9B32-ED1F2AEA8426}"/>
                </a:ext>
              </a:extLst>
            </p:cNvPr>
            <p:cNvSpPr txBox="1"/>
            <p:nvPr/>
          </p:nvSpPr>
          <p:spPr>
            <a:xfrm>
              <a:off x="2801324" y="431217"/>
              <a:ext cx="166981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L / HDL ≤ 2.0 </a:t>
              </a:r>
            </a:p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 = 11)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E1ABA3A-C79D-4F8E-9EB0-AB1DFFE76FA6}"/>
                </a:ext>
              </a:extLst>
            </p:cNvPr>
            <p:cNvSpPr txBox="1"/>
            <p:nvPr/>
          </p:nvSpPr>
          <p:spPr>
            <a:xfrm>
              <a:off x="2889082" y="1445871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7.26 ± 30.65</a:t>
              </a: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A6C2BD15-4D4B-454F-86C6-19F7BB9AA37D}"/>
                </a:ext>
              </a:extLst>
            </p:cNvPr>
            <p:cNvSpPr txBox="1"/>
            <p:nvPr/>
          </p:nvSpPr>
          <p:spPr>
            <a:xfrm>
              <a:off x="2877050" y="1700632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0.71 ± 17.5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439894D8-8478-4FCB-B62D-2C2E33F5513B}"/>
                </a:ext>
              </a:extLst>
            </p:cNvPr>
            <p:cNvSpPr txBox="1"/>
            <p:nvPr/>
          </p:nvSpPr>
          <p:spPr>
            <a:xfrm>
              <a:off x="2979642" y="1955393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.49 ± 9.2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85773BD-B5AD-4F77-8293-E38ED0ECCD89}"/>
                </a:ext>
              </a:extLst>
            </p:cNvPr>
            <p:cNvSpPr txBox="1"/>
            <p:nvPr/>
          </p:nvSpPr>
          <p:spPr>
            <a:xfrm>
              <a:off x="2979642" y="2210154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.22 ± 5.7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871A27EF-6B80-4F19-8EDF-6C622AD389AC}"/>
                </a:ext>
              </a:extLst>
            </p:cNvPr>
            <p:cNvSpPr txBox="1"/>
            <p:nvPr/>
          </p:nvSpPr>
          <p:spPr>
            <a:xfrm>
              <a:off x="2979642" y="2464915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.49 ± 5.9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206B23BA-B5D5-4E08-8E16-5A8EB64FBDF5}"/>
                </a:ext>
              </a:extLst>
            </p:cNvPr>
            <p:cNvSpPr txBox="1"/>
            <p:nvPr/>
          </p:nvSpPr>
          <p:spPr>
            <a:xfrm>
              <a:off x="2979642" y="2719677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4.97 ± 9.2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F685CDF4-D94E-45BD-822A-EF123AAE3214}"/>
                </a:ext>
              </a:extLst>
            </p:cNvPr>
            <p:cNvSpPr txBox="1"/>
            <p:nvPr/>
          </p:nvSpPr>
          <p:spPr>
            <a:xfrm>
              <a:off x="2979642" y="2974438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.48 ± 4.73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88E275B1-70E3-46AE-9457-59AC3A3603A5}"/>
                </a:ext>
              </a:extLst>
            </p:cNvPr>
            <p:cNvSpPr txBox="1"/>
            <p:nvPr/>
          </p:nvSpPr>
          <p:spPr>
            <a:xfrm>
              <a:off x="2877052" y="3229199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3.56 ± 19.7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3E02389B-2A73-4C07-8309-4C8F75DB83D0}"/>
                </a:ext>
              </a:extLst>
            </p:cNvPr>
            <p:cNvSpPr txBox="1"/>
            <p:nvPr/>
          </p:nvSpPr>
          <p:spPr>
            <a:xfrm>
              <a:off x="3067035" y="3738721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62 ± 0.5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F34C1EDF-5538-4824-B6C7-FDF4FBCFDCED}"/>
                </a:ext>
              </a:extLst>
            </p:cNvPr>
            <p:cNvSpPr txBox="1"/>
            <p:nvPr/>
          </p:nvSpPr>
          <p:spPr>
            <a:xfrm>
              <a:off x="2868834" y="3993481"/>
              <a:ext cx="15107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2.85 ± 22.7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A48D78B2-ABCD-4C6D-9B96-A4FEDC1C39DC}"/>
                </a:ext>
              </a:extLst>
            </p:cNvPr>
            <p:cNvSpPr txBox="1"/>
            <p:nvPr/>
          </p:nvSpPr>
          <p:spPr>
            <a:xfrm>
              <a:off x="2877052" y="4248242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8.36 ± 27.36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10F3B769-DDF0-4572-AE06-CA1FC73923F2}"/>
                </a:ext>
              </a:extLst>
            </p:cNvPr>
            <p:cNvSpPr txBox="1"/>
            <p:nvPr/>
          </p:nvSpPr>
          <p:spPr>
            <a:xfrm>
              <a:off x="2877052" y="4503003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4.07 ± 66.8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E1B71C91-33C7-4993-BFBE-3B0E0BD73286}"/>
                </a:ext>
              </a:extLst>
            </p:cNvPr>
            <p:cNvSpPr txBox="1"/>
            <p:nvPr/>
          </p:nvSpPr>
          <p:spPr>
            <a:xfrm>
              <a:off x="2976474" y="4757764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5.31 ± 15.4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7EA60D34-FE36-4791-92C1-1403A5D4653C}"/>
                </a:ext>
              </a:extLst>
            </p:cNvPr>
            <p:cNvSpPr txBox="1"/>
            <p:nvPr/>
          </p:nvSpPr>
          <p:spPr>
            <a:xfrm>
              <a:off x="2976474" y="5012526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.88 ± 10.3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2418F8AB-E485-4BD7-99D4-BC958D9175B4}"/>
                </a:ext>
              </a:extLst>
            </p:cNvPr>
            <p:cNvSpPr txBox="1"/>
            <p:nvPr/>
          </p:nvSpPr>
          <p:spPr>
            <a:xfrm>
              <a:off x="2877052" y="5267287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3.26 ± 39.4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027C56A7-1C7A-4FD2-8250-070E3741774B}"/>
                </a:ext>
              </a:extLst>
            </p:cNvPr>
            <p:cNvSpPr txBox="1"/>
            <p:nvPr/>
          </p:nvSpPr>
          <p:spPr>
            <a:xfrm>
              <a:off x="2877052" y="5522048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5.92 ± 57.8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FB69CC29-676F-418C-A5FC-44D0DDA5613D}"/>
                </a:ext>
              </a:extLst>
            </p:cNvPr>
            <p:cNvSpPr txBox="1"/>
            <p:nvPr/>
          </p:nvSpPr>
          <p:spPr>
            <a:xfrm>
              <a:off x="2979642" y="5776809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.47 ± 5.3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51E1291B-59D9-4004-8943-07D66AB0A4B2}"/>
                </a:ext>
              </a:extLst>
            </p:cNvPr>
            <p:cNvSpPr txBox="1"/>
            <p:nvPr/>
          </p:nvSpPr>
          <p:spPr>
            <a:xfrm>
              <a:off x="2988506" y="6031570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8.34 ± 13.2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2443FB99-BA53-4701-B48F-6A85F14B474D}"/>
                </a:ext>
              </a:extLst>
            </p:cNvPr>
            <p:cNvSpPr txBox="1"/>
            <p:nvPr/>
          </p:nvSpPr>
          <p:spPr>
            <a:xfrm>
              <a:off x="2991674" y="6286330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.81 ± 9.2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815F240A-180C-486C-B0C1-63149C68BA0B}"/>
                </a:ext>
              </a:extLst>
            </p:cNvPr>
            <p:cNvSpPr txBox="1"/>
            <p:nvPr/>
          </p:nvSpPr>
          <p:spPr>
            <a:xfrm>
              <a:off x="2991674" y="6541091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.15 ± 6.0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5BCC3809-8807-4C80-A069-DE0EEFCE88B6}"/>
                </a:ext>
              </a:extLst>
            </p:cNvPr>
            <p:cNvSpPr txBox="1"/>
            <p:nvPr/>
          </p:nvSpPr>
          <p:spPr>
            <a:xfrm>
              <a:off x="2991674" y="6795852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.95 ± 4.8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44AE12A1-2739-4034-987F-5CDAE7426526}"/>
                </a:ext>
              </a:extLst>
            </p:cNvPr>
            <p:cNvSpPr txBox="1"/>
            <p:nvPr/>
          </p:nvSpPr>
          <p:spPr>
            <a:xfrm>
              <a:off x="2877052" y="3483960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1.84 ± 28.83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D6C6AD69-F038-4CE1-8CF9-4AAE861477F6}"/>
                </a:ext>
              </a:extLst>
            </p:cNvPr>
            <p:cNvSpPr txBox="1"/>
            <p:nvPr/>
          </p:nvSpPr>
          <p:spPr>
            <a:xfrm>
              <a:off x="2991674" y="7305375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44 ± 3.3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36CC63E0-8FFF-47CE-B07B-2951EBF39E59}"/>
                </a:ext>
              </a:extLst>
            </p:cNvPr>
            <p:cNvSpPr txBox="1"/>
            <p:nvPr/>
          </p:nvSpPr>
          <p:spPr>
            <a:xfrm>
              <a:off x="2988506" y="7560135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.71 ± 19.6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6816F607-DF0B-47F3-8779-A519F340CFBD}"/>
                </a:ext>
              </a:extLst>
            </p:cNvPr>
            <p:cNvSpPr txBox="1"/>
            <p:nvPr/>
          </p:nvSpPr>
          <p:spPr>
            <a:xfrm>
              <a:off x="3003706" y="7814896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.23 ± 6.2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4B0F412E-DDA0-4FB3-8A07-1108A27C1F76}"/>
                </a:ext>
              </a:extLst>
            </p:cNvPr>
            <p:cNvSpPr txBox="1"/>
            <p:nvPr/>
          </p:nvSpPr>
          <p:spPr>
            <a:xfrm>
              <a:off x="2798521" y="8069657"/>
              <a:ext cx="17235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27.90 ± 258.2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64FEF357-D31C-4C05-BD10-F8E9CA5EF328}"/>
                </a:ext>
              </a:extLst>
            </p:cNvPr>
            <p:cNvSpPr txBox="1"/>
            <p:nvPr/>
          </p:nvSpPr>
          <p:spPr>
            <a:xfrm>
              <a:off x="2798521" y="8324418"/>
              <a:ext cx="17235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65.90 ± 181.9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ABD7AD3A-D64F-49E2-AF8D-FA38F744814D}"/>
                </a:ext>
              </a:extLst>
            </p:cNvPr>
            <p:cNvSpPr txBox="1"/>
            <p:nvPr/>
          </p:nvSpPr>
          <p:spPr>
            <a:xfrm>
              <a:off x="2901114" y="8579179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2.01 ± 93.6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EAF75846-E5D8-4802-9671-2CD2F8CCEA8D}"/>
                </a:ext>
              </a:extLst>
            </p:cNvPr>
            <p:cNvSpPr txBox="1"/>
            <p:nvPr/>
          </p:nvSpPr>
          <p:spPr>
            <a:xfrm>
              <a:off x="2901114" y="8833940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6.46 ± 53.3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79207457-68CD-49A2-A161-23A0430B3648}"/>
                </a:ext>
              </a:extLst>
            </p:cNvPr>
            <p:cNvSpPr txBox="1"/>
            <p:nvPr/>
          </p:nvSpPr>
          <p:spPr>
            <a:xfrm>
              <a:off x="3103130" y="9088701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5 ± 0.0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7508A8B6-2CF7-4573-BFF4-A7E63EE6A3AF}"/>
                </a:ext>
              </a:extLst>
            </p:cNvPr>
            <p:cNvSpPr txBox="1"/>
            <p:nvPr/>
          </p:nvSpPr>
          <p:spPr>
            <a:xfrm>
              <a:off x="3091098" y="9343462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7 ± 0.0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5063BF67-3CCB-4C99-9DD4-500F08CDB27E}"/>
                </a:ext>
              </a:extLst>
            </p:cNvPr>
            <p:cNvSpPr txBox="1"/>
            <p:nvPr/>
          </p:nvSpPr>
          <p:spPr>
            <a:xfrm>
              <a:off x="3103130" y="9598223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3 ± 0.4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50E2E8A2-C981-4381-BD87-2261750ABC37}"/>
                </a:ext>
              </a:extLst>
            </p:cNvPr>
            <p:cNvSpPr txBox="1"/>
            <p:nvPr/>
          </p:nvSpPr>
          <p:spPr>
            <a:xfrm>
              <a:off x="2991674" y="7050613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36 ± 5.06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F13B2231-6F39-4F73-824F-5B6F0B04725E}"/>
                </a:ext>
              </a:extLst>
            </p:cNvPr>
            <p:cNvSpPr txBox="1"/>
            <p:nvPr/>
          </p:nvSpPr>
          <p:spPr>
            <a:xfrm>
              <a:off x="4689107" y="1439605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6.64 ± 31.42</a:t>
              </a: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E47D1B03-B53C-416D-AAED-A76BDE4D66E8}"/>
                </a:ext>
              </a:extLst>
            </p:cNvPr>
            <p:cNvSpPr txBox="1"/>
            <p:nvPr/>
          </p:nvSpPr>
          <p:spPr>
            <a:xfrm>
              <a:off x="4704954" y="1694562"/>
              <a:ext cx="15107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9.92 ± 19.3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84F83938-0B34-4921-BA9E-05876FCAB583}"/>
                </a:ext>
              </a:extLst>
            </p:cNvPr>
            <p:cNvSpPr txBox="1"/>
            <p:nvPr/>
          </p:nvSpPr>
          <p:spPr>
            <a:xfrm>
              <a:off x="4800563" y="1949519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9.46 ± 12.0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B3E93DCE-B6A1-4490-B861-DBAEA43D1D5D}"/>
                </a:ext>
              </a:extLst>
            </p:cNvPr>
            <p:cNvSpPr txBox="1"/>
            <p:nvPr/>
          </p:nvSpPr>
          <p:spPr>
            <a:xfrm>
              <a:off x="4803731" y="2204476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.21 ± 7.4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46C37611-DCF6-4460-8276-060BA26B815D}"/>
                </a:ext>
              </a:extLst>
            </p:cNvPr>
            <p:cNvSpPr txBox="1"/>
            <p:nvPr/>
          </p:nvSpPr>
          <p:spPr>
            <a:xfrm>
              <a:off x="4803731" y="2459433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3.75 ± 4.1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75F1611-3B8C-43CD-9FEE-FAAD3BC4300A}"/>
                </a:ext>
              </a:extLst>
            </p:cNvPr>
            <p:cNvSpPr txBox="1"/>
            <p:nvPr/>
          </p:nvSpPr>
          <p:spPr>
            <a:xfrm>
              <a:off x="4803732" y="2714390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4.73 ± 7.4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6D2DF332-3EEE-4A60-B438-38AE52F7659A}"/>
                </a:ext>
              </a:extLst>
            </p:cNvPr>
            <p:cNvSpPr txBox="1"/>
            <p:nvPr/>
          </p:nvSpPr>
          <p:spPr>
            <a:xfrm>
              <a:off x="4803732" y="2969347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.39 ± 3.5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1C773B2A-A754-4A17-B96F-60394D666CA2}"/>
                </a:ext>
              </a:extLst>
            </p:cNvPr>
            <p:cNvSpPr txBox="1"/>
            <p:nvPr/>
          </p:nvSpPr>
          <p:spPr>
            <a:xfrm>
              <a:off x="4800562" y="3224305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.19 ± 19.1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4F023BB4-5ED0-4E75-956C-8C1A19CCC28B}"/>
                </a:ext>
              </a:extLst>
            </p:cNvPr>
            <p:cNvSpPr txBox="1"/>
            <p:nvPr/>
          </p:nvSpPr>
          <p:spPr>
            <a:xfrm>
              <a:off x="4903156" y="3734218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86 ± 0.4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FEF1DD1B-B0B0-4F50-AB13-BD51FE8707DC}"/>
                </a:ext>
              </a:extLst>
            </p:cNvPr>
            <p:cNvSpPr txBox="1"/>
            <p:nvPr/>
          </p:nvSpPr>
          <p:spPr>
            <a:xfrm>
              <a:off x="4701140" y="3989175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8.56 ± 15.5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E300966D-FDF1-4475-B049-C02709C85493}"/>
                </a:ext>
              </a:extLst>
            </p:cNvPr>
            <p:cNvSpPr txBox="1"/>
            <p:nvPr/>
          </p:nvSpPr>
          <p:spPr>
            <a:xfrm>
              <a:off x="4701140" y="4244133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4.66 ± 24.9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7ADFDC38-42F5-4E6C-9172-C3F071957984}"/>
                </a:ext>
              </a:extLst>
            </p:cNvPr>
            <p:cNvSpPr txBox="1"/>
            <p:nvPr/>
          </p:nvSpPr>
          <p:spPr>
            <a:xfrm>
              <a:off x="4689108" y="4499090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5.29 ± 61.1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70077515-0B0B-4A5B-86E0-590C9EC89971}"/>
                </a:ext>
              </a:extLst>
            </p:cNvPr>
            <p:cNvSpPr txBox="1"/>
            <p:nvPr/>
          </p:nvSpPr>
          <p:spPr>
            <a:xfrm>
              <a:off x="4788530" y="4754047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1.97 ± 12.6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97C8F808-EECA-4032-8896-E07AFBE8CD55}"/>
                </a:ext>
              </a:extLst>
            </p:cNvPr>
            <p:cNvSpPr txBox="1"/>
            <p:nvPr/>
          </p:nvSpPr>
          <p:spPr>
            <a:xfrm>
              <a:off x="4788530" y="5009003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6.53 ± 10.3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9D84428E-D975-4484-BC2A-F6EE5CFED09A}"/>
                </a:ext>
              </a:extLst>
            </p:cNvPr>
            <p:cNvSpPr txBox="1"/>
            <p:nvPr/>
          </p:nvSpPr>
          <p:spPr>
            <a:xfrm>
              <a:off x="4689108" y="5263960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5.32 ± 42.9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35C9AF8C-AA96-4610-B70F-DF03571354DD}"/>
                </a:ext>
              </a:extLst>
            </p:cNvPr>
            <p:cNvSpPr txBox="1"/>
            <p:nvPr/>
          </p:nvSpPr>
          <p:spPr>
            <a:xfrm>
              <a:off x="4692923" y="5518918"/>
              <a:ext cx="15107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1.20 ± 46.6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BBDAC1BB-ADF5-4850-8D38-8A8E2F497CD5}"/>
                </a:ext>
              </a:extLst>
            </p:cNvPr>
            <p:cNvSpPr txBox="1"/>
            <p:nvPr/>
          </p:nvSpPr>
          <p:spPr>
            <a:xfrm>
              <a:off x="4791700" y="5773875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49 ± 2.5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CD245584-7205-4108-8979-EDAF5F723D5E}"/>
                </a:ext>
              </a:extLst>
            </p:cNvPr>
            <p:cNvSpPr txBox="1"/>
            <p:nvPr/>
          </p:nvSpPr>
          <p:spPr>
            <a:xfrm>
              <a:off x="4788530" y="6028831"/>
              <a:ext cx="141577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.89 ± 13.33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29D9B775-96CD-428D-ABB0-1BF89FE90EAD}"/>
                </a:ext>
              </a:extLst>
            </p:cNvPr>
            <p:cNvSpPr txBox="1"/>
            <p:nvPr/>
          </p:nvSpPr>
          <p:spPr>
            <a:xfrm>
              <a:off x="4791700" y="6283788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.97 ± 8.01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27BCB15B-5E3D-457C-87A8-02F24BFAF14F}"/>
                </a:ext>
              </a:extLst>
            </p:cNvPr>
            <p:cNvSpPr txBox="1"/>
            <p:nvPr/>
          </p:nvSpPr>
          <p:spPr>
            <a:xfrm>
              <a:off x="4791700" y="6538746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.49 ± 4.1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B6E59953-FFD8-4783-86A1-2311C0CBA265}"/>
                </a:ext>
              </a:extLst>
            </p:cNvPr>
            <p:cNvSpPr txBox="1"/>
            <p:nvPr/>
          </p:nvSpPr>
          <p:spPr>
            <a:xfrm>
              <a:off x="4780316" y="6793703"/>
              <a:ext cx="1408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.09 ± 11.4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23A6EA95-0D06-4B4B-A397-4FAE976E7350}"/>
                </a:ext>
              </a:extLst>
            </p:cNvPr>
            <p:cNvSpPr txBox="1"/>
            <p:nvPr/>
          </p:nvSpPr>
          <p:spPr>
            <a:xfrm>
              <a:off x="4701140" y="3479262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4.70 ± 19.27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1C8F8230-2B88-4026-A1A4-A51E0885BE37}"/>
                </a:ext>
              </a:extLst>
            </p:cNvPr>
            <p:cNvSpPr txBox="1"/>
            <p:nvPr/>
          </p:nvSpPr>
          <p:spPr>
            <a:xfrm>
              <a:off x="4791700" y="7303616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22 ± 3.89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1D01F700-B61C-40D9-B7E0-684F065D5E3F}"/>
                </a:ext>
              </a:extLst>
            </p:cNvPr>
            <p:cNvSpPr txBox="1"/>
            <p:nvPr/>
          </p:nvSpPr>
          <p:spPr>
            <a:xfrm>
              <a:off x="4891123" y="7558573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.48 ± 1.5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0F3BB031-27EC-4153-9B2B-E20DB1E28C5C}"/>
                </a:ext>
              </a:extLst>
            </p:cNvPr>
            <p:cNvSpPr txBox="1"/>
            <p:nvPr/>
          </p:nvSpPr>
          <p:spPr>
            <a:xfrm>
              <a:off x="4779667" y="7813530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.57 ± 4.0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44424183-83E4-4FED-9AC7-FBB1C2FCA298}"/>
                </a:ext>
              </a:extLst>
            </p:cNvPr>
            <p:cNvSpPr txBox="1"/>
            <p:nvPr/>
          </p:nvSpPr>
          <p:spPr>
            <a:xfrm>
              <a:off x="4586514" y="8068487"/>
              <a:ext cx="17235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09.43 ± 258.03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4A8EE5DB-8EDC-4D68-AAD8-EA21AE1C69F7}"/>
                </a:ext>
              </a:extLst>
            </p:cNvPr>
            <p:cNvSpPr txBox="1"/>
            <p:nvPr/>
          </p:nvSpPr>
          <p:spPr>
            <a:xfrm>
              <a:off x="4586514" y="8323444"/>
              <a:ext cx="17235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67.98 ± 403.0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FFA2F986-C984-4BE8-ABFB-926BAEA763B2}"/>
                </a:ext>
              </a:extLst>
            </p:cNvPr>
            <p:cNvSpPr txBox="1"/>
            <p:nvPr/>
          </p:nvSpPr>
          <p:spPr>
            <a:xfrm>
              <a:off x="4685939" y="8578401"/>
              <a:ext cx="16209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47.00 ± 104.53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C7D59FB0-4C4D-481A-8BC1-7886D6EDF5F6}"/>
                </a:ext>
              </a:extLst>
            </p:cNvPr>
            <p:cNvSpPr txBox="1"/>
            <p:nvPr/>
          </p:nvSpPr>
          <p:spPr>
            <a:xfrm>
              <a:off x="4689107" y="8833358"/>
              <a:ext cx="151836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6.02 ± 60.00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DE37A39D-FEE7-443D-8F0D-4BC67788FF16}"/>
                </a:ext>
              </a:extLst>
            </p:cNvPr>
            <p:cNvSpPr txBox="1"/>
            <p:nvPr/>
          </p:nvSpPr>
          <p:spPr>
            <a:xfrm>
              <a:off x="4903155" y="9088315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4 ± 0.05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8FB2D452-FE0B-4B9F-9054-0C2CB1091BCA}"/>
                </a:ext>
              </a:extLst>
            </p:cNvPr>
            <p:cNvSpPr txBox="1"/>
            <p:nvPr/>
          </p:nvSpPr>
          <p:spPr>
            <a:xfrm>
              <a:off x="4915187" y="9343272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7 ± 0.02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22C8A82B-6515-4EF8-9358-9DC8A3FC2C48}"/>
                </a:ext>
              </a:extLst>
            </p:cNvPr>
            <p:cNvSpPr txBox="1"/>
            <p:nvPr/>
          </p:nvSpPr>
          <p:spPr>
            <a:xfrm>
              <a:off x="4915187" y="9598223"/>
              <a:ext cx="121058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2 ± 0.38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54C3D5CF-55D2-465C-83A8-05CEAEE06331}"/>
                </a:ext>
              </a:extLst>
            </p:cNvPr>
            <p:cNvSpPr txBox="1"/>
            <p:nvPr/>
          </p:nvSpPr>
          <p:spPr>
            <a:xfrm>
              <a:off x="4791700" y="7048660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85 ± 6.86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54E296C9-F6E7-403B-A783-7BBC85A4AFD6}"/>
                </a:ext>
              </a:extLst>
            </p:cNvPr>
            <p:cNvSpPr txBox="1"/>
            <p:nvPr/>
          </p:nvSpPr>
          <p:spPr>
            <a:xfrm>
              <a:off x="4565805" y="431217"/>
              <a:ext cx="1764970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L / HDL  &gt; 2.0 </a:t>
              </a:r>
            </a:p>
            <a:p>
              <a:pPr algn="ct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=15)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B5F1586-D12C-4BD6-B8E3-36D60747D834}"/>
                </a:ext>
              </a:extLst>
            </p:cNvPr>
            <p:cNvSpPr txBox="1"/>
            <p:nvPr/>
          </p:nvSpPr>
          <p:spPr>
            <a:xfrm>
              <a:off x="2061003" y="936349"/>
              <a:ext cx="5950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MI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77E8E1C2-EB19-4546-8FCE-67E12F4CD7DD}"/>
                </a:ext>
              </a:extLst>
            </p:cNvPr>
            <p:cNvSpPr txBox="1"/>
            <p:nvPr/>
          </p:nvSpPr>
          <p:spPr>
            <a:xfrm>
              <a:off x="1572089" y="1191110"/>
              <a:ext cx="10839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A-IR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74DA5F4A-9C03-40F1-8623-BE439B254F3F}"/>
                </a:ext>
              </a:extLst>
            </p:cNvPr>
            <p:cNvSpPr txBox="1"/>
            <p:nvPr/>
          </p:nvSpPr>
          <p:spPr>
            <a:xfrm>
              <a:off x="3014078" y="936349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.40 ± 2.21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23976ABD-D856-44D7-9D54-F04AED8331C9}"/>
                </a:ext>
              </a:extLst>
            </p:cNvPr>
            <p:cNvSpPr txBox="1"/>
            <p:nvPr/>
          </p:nvSpPr>
          <p:spPr>
            <a:xfrm>
              <a:off x="3095058" y="1191110"/>
              <a:ext cx="12105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74 ± 2.77</a:t>
              </a: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43C80988-46AF-4E95-AF64-C689464E9C44}"/>
                </a:ext>
              </a:extLst>
            </p:cNvPr>
            <p:cNvSpPr txBox="1"/>
            <p:nvPr/>
          </p:nvSpPr>
          <p:spPr>
            <a:xfrm>
              <a:off x="4790039" y="929691"/>
              <a:ext cx="13131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.40 ± 2.64</a:t>
              </a:r>
              <a:endPara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0E209158-C9AF-4663-B8B7-771B91705E2D}"/>
                </a:ext>
              </a:extLst>
            </p:cNvPr>
            <p:cNvSpPr txBox="1"/>
            <p:nvPr/>
          </p:nvSpPr>
          <p:spPr>
            <a:xfrm>
              <a:off x="4895083" y="1184648"/>
              <a:ext cx="12105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1 ± 1.44</a:t>
              </a:r>
            </a:p>
          </p:txBody>
        </p:sp>
      </p:grp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B0B47B97-DF0B-4368-8B61-35D1485D5D45}"/>
              </a:ext>
            </a:extLst>
          </p:cNvPr>
          <p:cNvSpPr txBox="1"/>
          <p:nvPr/>
        </p:nvSpPr>
        <p:spPr>
          <a:xfrm>
            <a:off x="0" y="480430"/>
            <a:ext cx="466794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ja-JP" altLang="en-US" sz="2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3047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B2AB9C33-3819-4979-96FC-A7D5ABBDA854}"/>
              </a:ext>
            </a:extLst>
          </p:cNvPr>
          <p:cNvGrpSpPr/>
          <p:nvPr/>
        </p:nvGrpSpPr>
        <p:grpSpPr>
          <a:xfrm>
            <a:off x="0" y="830266"/>
            <a:ext cx="6729513" cy="4981165"/>
            <a:chOff x="0" y="331503"/>
            <a:chExt cx="6729513" cy="4981165"/>
          </a:xfrm>
        </p:grpSpPr>
        <p:graphicFrame>
          <p:nvGraphicFramePr>
            <p:cNvPr id="5" name="グラフ 4">
              <a:extLst>
                <a:ext uri="{FF2B5EF4-FFF2-40B4-BE49-F238E27FC236}">
                  <a16:creationId xmlns:a16="http://schemas.microsoft.com/office/drawing/2014/main" id="{14F1476D-871B-4539-A193-97905A978DA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3742349"/>
                </p:ext>
              </p:extLst>
            </p:nvPr>
          </p:nvGraphicFramePr>
          <p:xfrm>
            <a:off x="387834" y="626336"/>
            <a:ext cx="28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CF4ABE73-F13B-490E-91AE-085FF18EA49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3893703"/>
                </p:ext>
              </p:extLst>
            </p:nvPr>
          </p:nvGraphicFramePr>
          <p:xfrm>
            <a:off x="3849513" y="626336"/>
            <a:ext cx="28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グラフ 6">
              <a:extLst>
                <a:ext uri="{FF2B5EF4-FFF2-40B4-BE49-F238E27FC236}">
                  <a16:creationId xmlns:a16="http://schemas.microsoft.com/office/drawing/2014/main" id="{BCEB2C6B-C2A3-4854-A9CE-4D438AC71F1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7785695"/>
                </p:ext>
              </p:extLst>
            </p:nvPr>
          </p:nvGraphicFramePr>
          <p:xfrm>
            <a:off x="387834" y="3103763"/>
            <a:ext cx="28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E2BAC39-2972-4923-A96E-9A0C77EBA2D2}"/>
                </a:ext>
              </a:extLst>
            </p:cNvPr>
            <p:cNvSpPr txBox="1"/>
            <p:nvPr/>
          </p:nvSpPr>
          <p:spPr>
            <a:xfrm rot="16200000">
              <a:off x="3031656" y="1326282"/>
              <a:ext cx="134043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L/HDL</a:t>
              </a:r>
              <a:endPara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26B8E30-6DE1-4862-9138-6575459A92ED}"/>
                </a:ext>
              </a:extLst>
            </p:cNvPr>
            <p:cNvSpPr txBox="1"/>
            <p:nvPr/>
          </p:nvSpPr>
          <p:spPr>
            <a:xfrm rot="16200000">
              <a:off x="-390157" y="1326282"/>
              <a:ext cx="134043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L/HDL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211B389-2973-43AD-BB90-7D1458F06D40}"/>
                </a:ext>
              </a:extLst>
            </p:cNvPr>
            <p:cNvSpPr txBox="1"/>
            <p:nvPr/>
          </p:nvSpPr>
          <p:spPr>
            <a:xfrm rot="16200000">
              <a:off x="-390158" y="3649821"/>
              <a:ext cx="134043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DL/HDL</a:t>
              </a:r>
              <a:endParaRPr lang="ja-JP" altLang="en-US" sz="2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8ABCAA-8BB2-4D8E-A368-5DCAB9024951}"/>
                </a:ext>
              </a:extLst>
            </p:cNvPr>
            <p:cNvSpPr txBox="1"/>
            <p:nvPr/>
          </p:nvSpPr>
          <p:spPr>
            <a:xfrm>
              <a:off x="1058137" y="2455586"/>
              <a:ext cx="15393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T (Right)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0B9B967-505F-4E48-BE2B-212A0C759D5F}"/>
                </a:ext>
              </a:extLst>
            </p:cNvPr>
            <p:cNvSpPr txBox="1"/>
            <p:nvPr/>
          </p:nvSpPr>
          <p:spPr>
            <a:xfrm>
              <a:off x="1050924" y="4912558"/>
              <a:ext cx="155382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T (Mean)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73D7DE2-7D89-4789-90E7-2E0B9E8ADF93}"/>
                </a:ext>
              </a:extLst>
            </p:cNvPr>
            <p:cNvSpPr txBox="1"/>
            <p:nvPr/>
          </p:nvSpPr>
          <p:spPr>
            <a:xfrm>
              <a:off x="0" y="331503"/>
              <a:ext cx="4347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1718C59-1594-4602-875E-1E87DA13FBAC}"/>
                </a:ext>
              </a:extLst>
            </p:cNvPr>
            <p:cNvSpPr txBox="1"/>
            <p:nvPr/>
          </p:nvSpPr>
          <p:spPr>
            <a:xfrm>
              <a:off x="3449699" y="350553"/>
              <a:ext cx="42030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56DDC0F-C9E1-44E5-BD0A-5C9099570456}"/>
                </a:ext>
              </a:extLst>
            </p:cNvPr>
            <p:cNvSpPr txBox="1"/>
            <p:nvPr/>
          </p:nvSpPr>
          <p:spPr>
            <a:xfrm>
              <a:off x="0" y="2816525"/>
              <a:ext cx="4347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1CB37C80-C32A-4C61-8DA8-86E3D3EA61B7}"/>
                </a:ext>
              </a:extLst>
            </p:cNvPr>
            <p:cNvSpPr txBox="1"/>
            <p:nvPr/>
          </p:nvSpPr>
          <p:spPr>
            <a:xfrm>
              <a:off x="4598361" y="2455586"/>
              <a:ext cx="138230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T (Left)</a:t>
              </a:r>
              <a:endParaRPr kumimoji="1"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F9A6059-9827-4B74-BBA9-DF87BE53F700}"/>
              </a:ext>
            </a:extLst>
          </p:cNvPr>
          <p:cNvSpPr txBox="1"/>
          <p:nvPr/>
        </p:nvSpPr>
        <p:spPr>
          <a:xfrm>
            <a:off x="0" y="0"/>
            <a:ext cx="3429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2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1209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0" y="480430"/>
            <a:ext cx="484428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ja-JP" altLang="en-US" sz="2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1937132" y="846815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4" name="直線コネクタ 143"/>
          <p:cNvCxnSpPr/>
          <p:nvPr/>
        </p:nvCxnSpPr>
        <p:spPr>
          <a:xfrm flipH="1">
            <a:off x="636899" y="9906000"/>
            <a:ext cx="576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/>
          <p:cNvSpPr txBox="1"/>
          <p:nvPr/>
        </p:nvSpPr>
        <p:spPr>
          <a:xfrm>
            <a:off x="1798134" y="1361603"/>
            <a:ext cx="733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1692518" y="1618998"/>
            <a:ext cx="8531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c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1532218" y="1876392"/>
            <a:ext cx="1013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euc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1592953" y="2133786"/>
            <a:ext cx="8435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id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1237675" y="2391178"/>
            <a:ext cx="1202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ylalan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1421301" y="2648573"/>
            <a:ext cx="10151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1423034" y="2905967"/>
            <a:ext cx="1013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ion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1514404" y="3163361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on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1772745" y="3420756"/>
            <a:ext cx="6637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s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1785447" y="3935544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1680607" y="4192937"/>
            <a:ext cx="9332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1674839" y="4450331"/>
            <a:ext cx="843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1624244" y="4707725"/>
            <a:ext cx="9896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e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1437730" y="4965120"/>
            <a:ext cx="1162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amiate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712488" y="5222514"/>
            <a:ext cx="7922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479917" y="5479908"/>
            <a:ext cx="9428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550451" y="5737301"/>
            <a:ext cx="872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ll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1603413" y="5994695"/>
            <a:ext cx="819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Argin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1550449" y="6252089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nith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1419004" y="6509483"/>
            <a:ext cx="10038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arag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692862" y="6766878"/>
            <a:ext cx="7299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Taur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1688309" y="7024272"/>
            <a:ext cx="7344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t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1290120" y="3678150"/>
            <a:ext cx="1228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artic acid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043900" y="7281666"/>
            <a:ext cx="1378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prol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840319" y="7539059"/>
            <a:ext cx="15824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ethanolam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732918" y="7796453"/>
            <a:ext cx="1689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Aminobutyric acid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1761869" y="8053847"/>
            <a:ext cx="7291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AA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1739604" y="8311242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1861565" y="8568636"/>
            <a:ext cx="643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A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1738001" y="8826030"/>
            <a:ext cx="6848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1225041" y="9083423"/>
            <a:ext cx="1197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A / NE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1156944" y="9340817"/>
            <a:ext cx="1265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AA / TF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1335646" y="9598223"/>
            <a:ext cx="1087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cher ratio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テキスト ボックス 316"/>
          <p:cNvSpPr txBox="1"/>
          <p:nvPr/>
        </p:nvSpPr>
        <p:spPr>
          <a:xfrm>
            <a:off x="3311009" y="58715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4" name="直線コネクタ 323"/>
          <p:cNvCxnSpPr/>
          <p:nvPr/>
        </p:nvCxnSpPr>
        <p:spPr>
          <a:xfrm flipH="1">
            <a:off x="636899" y="860892"/>
            <a:ext cx="576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直線コネクタ 324"/>
          <p:cNvCxnSpPr/>
          <p:nvPr/>
        </p:nvCxnSpPr>
        <p:spPr>
          <a:xfrm flipH="1">
            <a:off x="642604" y="571477"/>
            <a:ext cx="576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テキスト ボックス 128"/>
          <p:cNvSpPr txBox="1"/>
          <p:nvPr/>
        </p:nvSpPr>
        <p:spPr>
          <a:xfrm>
            <a:off x="5198279" y="59694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1474643" y="1104209"/>
            <a:ext cx="1152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A-IR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853474" y="87411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17 ± 3.4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4790155" y="1361603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3.27 ± 20.76</a:t>
            </a: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4795812" y="161899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3.83 ± 14.2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4880770" y="1876392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2.37 ± 10.7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4880770" y="213378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.89 ± 6.3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4880770" y="239117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4.91 ± 1.9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4880770" y="264857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.36 ± 7.4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4880770" y="2905967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.14 ± 1.9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4797346" y="3163361"/>
            <a:ext cx="1344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8.06 ± 39.2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4977843" y="367815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70 ± 0.6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4809460" y="3935544"/>
            <a:ext cx="1344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8.06 ± 14.2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4795812" y="4192937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8.43 ± 37.8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4795812" y="4450331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0.47 ± 34.7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4880770" y="470772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7.00 ± 8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4880770" y="4965120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.50 ± 14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4783698" y="5222514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6.64 ± 28.1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782164" y="547990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7.40 ± 53.4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4880770" y="573730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10 ± 3.7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4880770" y="5994695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.53 ± 16.3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4894418" y="625208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.39 ± 7.8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4880770" y="650948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.09 ± 5.1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4880770" y="6766878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.49 ± 5.2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4795812" y="342075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2.44 ± 23.5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4880770" y="728166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29 ± 5.5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4964195" y="753905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24 ± 0.9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4880770" y="779645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63 ± 3.9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4698740" y="8053847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87.64 ± 227.9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4710852" y="8311242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93.37 ± 142.1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4795812" y="856863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94.27 ± 91.4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4795812" y="8826030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9.47 ± 40.6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4964195" y="90834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3 ± 0.0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4964195" y="9340817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6 ± 0.0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テキスト ボックス 176"/>
          <p:cNvSpPr txBox="1"/>
          <p:nvPr/>
        </p:nvSpPr>
        <p:spPr>
          <a:xfrm>
            <a:off x="4964195" y="95982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37 ± 0.3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4880770" y="7024272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59 ± 6.8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4950547" y="110420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83 ± 1.35</a:t>
            </a: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2895148" y="86046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.36 ± 3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2804534" y="1361603"/>
            <a:ext cx="13965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0.36 ± 49.13 </a:t>
            </a: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2810190" y="161899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7.67 ± 33.7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2908796" y="1876392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.29 ± 20.1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2908796" y="2133786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.67 ± 15.8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/>
          <p:cNvSpPr txBox="1"/>
          <p:nvPr/>
        </p:nvSpPr>
        <p:spPr>
          <a:xfrm>
            <a:off x="2922444" y="239117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.09 ± 8.5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>
            <a:off x="2922444" y="2648573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.64 ± 12.4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テキスト ボックス 309"/>
          <p:cNvSpPr txBox="1"/>
          <p:nvPr/>
        </p:nvSpPr>
        <p:spPr>
          <a:xfrm>
            <a:off x="2922444" y="2905967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.37 ± 6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テキスト ボックス 310"/>
          <p:cNvSpPr txBox="1"/>
          <p:nvPr/>
        </p:nvSpPr>
        <p:spPr>
          <a:xfrm>
            <a:off x="2852668" y="3163361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9.50 ± 33.0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テキスト ボックス 311"/>
          <p:cNvSpPr txBox="1"/>
          <p:nvPr/>
        </p:nvSpPr>
        <p:spPr>
          <a:xfrm>
            <a:off x="3019517" y="367815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7 ± 1.0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837486" y="3935544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7.99 ± 21.8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テキスト ボックス 313"/>
          <p:cNvSpPr txBox="1"/>
          <p:nvPr/>
        </p:nvSpPr>
        <p:spPr>
          <a:xfrm>
            <a:off x="2837486" y="4192937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8.81 ± 32.9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テキスト ボックス 314"/>
          <p:cNvSpPr txBox="1"/>
          <p:nvPr/>
        </p:nvSpPr>
        <p:spPr>
          <a:xfrm>
            <a:off x="2837486" y="4450331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5.54 ± 81.2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テキスト ボックス 315"/>
          <p:cNvSpPr txBox="1"/>
          <p:nvPr/>
        </p:nvSpPr>
        <p:spPr>
          <a:xfrm>
            <a:off x="2922444" y="4707725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4.96 ± 23.02</a:t>
            </a:r>
          </a:p>
        </p:txBody>
      </p:sp>
      <p:sp>
        <p:nvSpPr>
          <p:cNvPr id="318" name="テキスト ボックス 317"/>
          <p:cNvSpPr txBox="1"/>
          <p:nvPr/>
        </p:nvSpPr>
        <p:spPr>
          <a:xfrm>
            <a:off x="2922444" y="4965120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.36 ± 19.9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2839020" y="5222514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5.53 ± 52.0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テキスト ボックス 319"/>
          <p:cNvSpPr txBox="1"/>
          <p:nvPr/>
        </p:nvSpPr>
        <p:spPr>
          <a:xfrm>
            <a:off x="2837486" y="547990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0.81 ± 71.4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テキスト ボックス 320"/>
          <p:cNvSpPr txBox="1"/>
          <p:nvPr/>
        </p:nvSpPr>
        <p:spPr>
          <a:xfrm>
            <a:off x="2922444" y="573730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79 ± 4.3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>
            <a:off x="2908796" y="5994695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.87 ± 20.8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テキスト ボックス 322"/>
          <p:cNvSpPr txBox="1"/>
          <p:nvPr/>
        </p:nvSpPr>
        <p:spPr>
          <a:xfrm>
            <a:off x="2908796" y="6252089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.61 ± 14.9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2908796" y="6509483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8.01 ± 10.0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2908796" y="6766878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.34 ± 4.5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2837486" y="342075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2.00 ± 42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2908796" y="728166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.03 ± 5.1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2992221" y="753905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64 ± 0.8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/>
          <p:cNvSpPr txBox="1"/>
          <p:nvPr/>
        </p:nvSpPr>
        <p:spPr>
          <a:xfrm>
            <a:off x="2895148" y="779645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69 ± 5.9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/>
          <p:cNvSpPr txBox="1"/>
          <p:nvPr/>
        </p:nvSpPr>
        <p:spPr>
          <a:xfrm>
            <a:off x="2716458" y="8053846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66.41 ± 455.8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/>
          <p:cNvSpPr txBox="1"/>
          <p:nvPr/>
        </p:nvSpPr>
        <p:spPr>
          <a:xfrm>
            <a:off x="2711582" y="8311242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4.83 ± 264.7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テキスト ボックス 333"/>
          <p:cNvSpPr txBox="1"/>
          <p:nvPr/>
        </p:nvSpPr>
        <p:spPr>
          <a:xfrm>
            <a:off x="2796542" y="8568636"/>
            <a:ext cx="1441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1.59 ± 203.9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2782894" y="8826030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2.31 ± 99.1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テキスト ボックス 335"/>
          <p:cNvSpPr txBox="1"/>
          <p:nvPr/>
        </p:nvSpPr>
        <p:spPr>
          <a:xfrm>
            <a:off x="2978573" y="90834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6 ± 0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テキスト ボックス 336"/>
          <p:cNvSpPr txBox="1"/>
          <p:nvPr/>
        </p:nvSpPr>
        <p:spPr>
          <a:xfrm>
            <a:off x="2978573" y="9340817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8 ± 0.0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テキスト ボックス 337"/>
          <p:cNvSpPr txBox="1"/>
          <p:nvPr/>
        </p:nvSpPr>
        <p:spPr>
          <a:xfrm>
            <a:off x="2978573" y="95982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4 ± 0.4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2908796" y="7024272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53 ± 3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テキスト ボックス 339"/>
          <p:cNvSpPr txBox="1"/>
          <p:nvPr/>
        </p:nvSpPr>
        <p:spPr>
          <a:xfrm>
            <a:off x="2978573" y="110420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09 ± 4.02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9C1F061F-EE9F-4781-87B6-6A05E16A3D3C}"/>
              </a:ext>
            </a:extLst>
          </p:cNvPr>
          <p:cNvSpPr txBox="1"/>
          <p:nvPr/>
        </p:nvSpPr>
        <p:spPr>
          <a:xfrm>
            <a:off x="0" y="0"/>
            <a:ext cx="3111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ata 3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2927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テキスト ボックス 118"/>
          <p:cNvSpPr txBox="1"/>
          <p:nvPr/>
        </p:nvSpPr>
        <p:spPr>
          <a:xfrm>
            <a:off x="1863125" y="846815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4" name="直線コネクタ 143"/>
          <p:cNvCxnSpPr/>
          <p:nvPr/>
        </p:nvCxnSpPr>
        <p:spPr>
          <a:xfrm flipH="1">
            <a:off x="636899" y="9906000"/>
            <a:ext cx="576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テキスト ボックス 119"/>
          <p:cNvSpPr txBox="1"/>
          <p:nvPr/>
        </p:nvSpPr>
        <p:spPr>
          <a:xfrm>
            <a:off x="1716246" y="1361603"/>
            <a:ext cx="733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1596981" y="1618998"/>
            <a:ext cx="8531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c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1463978" y="1876392"/>
            <a:ext cx="1013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euc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1552009" y="2133786"/>
            <a:ext cx="8435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id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1177174" y="2391179"/>
            <a:ext cx="13821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ylalanine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1328635" y="2648573"/>
            <a:ext cx="1217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yptophan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1326209" y="2905967"/>
            <a:ext cx="12057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ionine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1432516" y="3163361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on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1642032" y="3420756"/>
            <a:ext cx="753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s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1697790" y="3935544"/>
            <a:ext cx="643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1612366" y="4192937"/>
            <a:ext cx="9332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1592951" y="4450331"/>
            <a:ext cx="843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an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1522942" y="4707725"/>
            <a:ext cx="899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os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1399767" y="4965120"/>
            <a:ext cx="10230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at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1630600" y="5222514"/>
            <a:ext cx="7922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1411678" y="5479908"/>
            <a:ext cx="942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utam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1482211" y="5737301"/>
            <a:ext cx="8723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ll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1537670" y="5994695"/>
            <a:ext cx="9124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inine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1495857" y="6252089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nith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1342885" y="6509483"/>
            <a:ext cx="10935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aragine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1651918" y="6766878"/>
            <a:ext cx="7299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urin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1596981" y="7024272"/>
            <a:ext cx="8531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tine</a:t>
            </a:r>
            <a:r>
              <a:rPr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79" name="テキスト ボックス 178"/>
          <p:cNvSpPr txBox="1"/>
          <p:nvPr/>
        </p:nvSpPr>
        <p:spPr>
          <a:xfrm>
            <a:off x="1188816" y="3678150"/>
            <a:ext cx="1138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partic acid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000664" y="7281666"/>
            <a:ext cx="1449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droxyproline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91494" y="7539059"/>
            <a:ext cx="1672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ethanolamine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/>
          <p:cNvSpPr txBox="1"/>
          <p:nvPr/>
        </p:nvSpPr>
        <p:spPr>
          <a:xfrm>
            <a:off x="732918" y="7796453"/>
            <a:ext cx="16898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-Aminobutyric acid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1767638" y="8053847"/>
            <a:ext cx="8189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AA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1725956" y="8311242"/>
            <a:ext cx="6832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1853685" y="8568636"/>
            <a:ext cx="7328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A*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1743769" y="8826030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AA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テキスト ボックス 188"/>
          <p:cNvSpPr txBox="1"/>
          <p:nvPr/>
        </p:nvSpPr>
        <p:spPr>
          <a:xfrm>
            <a:off x="1225041" y="9083423"/>
            <a:ext cx="1197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A / NE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1156944" y="9340817"/>
            <a:ext cx="1265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AA / TFAA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テキスト ボックス 190"/>
          <p:cNvSpPr txBox="1"/>
          <p:nvPr/>
        </p:nvSpPr>
        <p:spPr>
          <a:xfrm>
            <a:off x="1300470" y="9598223"/>
            <a:ext cx="1176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cher ratio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テキスト ボックス 316"/>
          <p:cNvSpPr txBox="1"/>
          <p:nvPr/>
        </p:nvSpPr>
        <p:spPr>
          <a:xfrm>
            <a:off x="3229121" y="587156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4" name="直線コネクタ 323"/>
          <p:cNvCxnSpPr/>
          <p:nvPr/>
        </p:nvCxnSpPr>
        <p:spPr>
          <a:xfrm flipH="1">
            <a:off x="636899" y="860892"/>
            <a:ext cx="576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直線コネクタ 324"/>
          <p:cNvCxnSpPr/>
          <p:nvPr/>
        </p:nvCxnSpPr>
        <p:spPr>
          <a:xfrm flipH="1">
            <a:off x="642604" y="571477"/>
            <a:ext cx="576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テキスト ボックス 128"/>
          <p:cNvSpPr txBox="1"/>
          <p:nvPr/>
        </p:nvSpPr>
        <p:spPr>
          <a:xfrm>
            <a:off x="5255429" y="596946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1414282" y="1104209"/>
            <a:ext cx="10631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MA-IR*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899820" y="84681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31 ± 2.4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4822853" y="1361603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2.21 ± 25.44</a:t>
            </a: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4869454" y="1618998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1.32± 13.2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4913468" y="1876392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.75 ± 10.1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4954412" y="2133786"/>
            <a:ext cx="1127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3.63± 6.9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4899820" y="239117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.19 ± 4.9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4899820" y="264857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.34 ± 4.9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テキスト ボックス 150"/>
          <p:cNvSpPr txBox="1"/>
          <p:nvPr/>
        </p:nvSpPr>
        <p:spPr>
          <a:xfrm>
            <a:off x="4899820" y="2905967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75 ± 2.4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テキスト ボックス 151"/>
          <p:cNvSpPr txBox="1"/>
          <p:nvPr/>
        </p:nvSpPr>
        <p:spPr>
          <a:xfrm>
            <a:off x="4898284" y="3163361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9.53 ± 29.8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テキスト ボックス 152"/>
          <p:cNvSpPr txBox="1"/>
          <p:nvPr/>
        </p:nvSpPr>
        <p:spPr>
          <a:xfrm>
            <a:off x="4996893" y="367815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77 ± 0.3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テキスト ボックス 153"/>
          <p:cNvSpPr txBox="1"/>
          <p:nvPr/>
        </p:nvSpPr>
        <p:spPr>
          <a:xfrm>
            <a:off x="4828510" y="3935544"/>
            <a:ext cx="1344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9.09 ± 11.9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4814862" y="4192937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7.64 ± 22.2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テキスト ボックス 155"/>
          <p:cNvSpPr txBox="1"/>
          <p:nvPr/>
        </p:nvSpPr>
        <p:spPr>
          <a:xfrm>
            <a:off x="4814862" y="4450331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38.90 ± 55.2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テキスト ボックス 156"/>
          <p:cNvSpPr txBox="1"/>
          <p:nvPr/>
        </p:nvSpPr>
        <p:spPr>
          <a:xfrm>
            <a:off x="4899820" y="470772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.71 ± 7.2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/>
          <p:cNvSpPr txBox="1"/>
          <p:nvPr/>
        </p:nvSpPr>
        <p:spPr>
          <a:xfrm>
            <a:off x="4899820" y="4965120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.46 ± 12.1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/>
          <p:cNvSpPr txBox="1"/>
          <p:nvPr/>
        </p:nvSpPr>
        <p:spPr>
          <a:xfrm>
            <a:off x="4802748" y="5222514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7.71 ± 32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4801214" y="547990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7.66 ± 65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4899820" y="573730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05 ± 4.4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4899820" y="599469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.19 ± 8.9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4886172" y="6252089"/>
            <a:ext cx="1255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.50 ± 11.5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4899820" y="650948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.60 ± 3.96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4899820" y="6766878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.76 ± 7.3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4814862" y="3420756"/>
            <a:ext cx="1344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5.13 ± 21.1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4899820" y="728166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36 ± 4.7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4996893" y="753905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59 ± 1.4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4899820" y="779645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.99 ± 5.2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4717790" y="8053847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42.56 ± 128.3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4716254" y="8311242"/>
            <a:ext cx="15245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64.64 ± 114.5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4801214" y="856863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77.92 ± 57.91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4801214" y="8826030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15.29 ± 43.6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>
            <a:off x="4969597" y="90834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3 ± 0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>
            <a:off x="4969597" y="9340817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6 ± 0.0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テキスト ボックス 176"/>
          <p:cNvSpPr txBox="1"/>
          <p:nvPr/>
        </p:nvSpPr>
        <p:spPr>
          <a:xfrm>
            <a:off x="4955949" y="95982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39 ± 0.3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テキスト ボックス 177"/>
          <p:cNvSpPr txBox="1"/>
          <p:nvPr/>
        </p:nvSpPr>
        <p:spPr>
          <a:xfrm>
            <a:off x="4899820" y="7024272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94 ± 5.9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4996893" y="110420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36 ± 4.07</a:t>
            </a:r>
          </a:p>
        </p:txBody>
      </p:sp>
      <p:sp>
        <p:nvSpPr>
          <p:cNvPr id="303" name="テキスト ボックス 302"/>
          <p:cNvSpPr txBox="1"/>
          <p:nvPr/>
        </p:nvSpPr>
        <p:spPr>
          <a:xfrm>
            <a:off x="2936092" y="84681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.93 ± 2.5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2859126" y="1361603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2.72 ± 24.50</a:t>
            </a: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2864782" y="1618998"/>
            <a:ext cx="1344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5.14 ± 14.4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テキスト ボックス 305"/>
          <p:cNvSpPr txBox="1"/>
          <p:nvPr/>
        </p:nvSpPr>
        <p:spPr>
          <a:xfrm>
            <a:off x="2936092" y="1876392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.87 ± 10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テキスト ボックス 306"/>
          <p:cNvSpPr txBox="1"/>
          <p:nvPr/>
        </p:nvSpPr>
        <p:spPr>
          <a:xfrm>
            <a:off x="2936092" y="213378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.74 ± 6.1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テキスト ボックス 307"/>
          <p:cNvSpPr txBox="1"/>
          <p:nvPr/>
        </p:nvSpPr>
        <p:spPr>
          <a:xfrm>
            <a:off x="2936092" y="239117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.15 ± 4.5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テキスト ボックス 308"/>
          <p:cNvSpPr txBox="1"/>
          <p:nvPr/>
        </p:nvSpPr>
        <p:spPr>
          <a:xfrm>
            <a:off x="2936092" y="264857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.46 ± 6.2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テキスト ボックス 309"/>
          <p:cNvSpPr txBox="1"/>
          <p:nvPr/>
        </p:nvSpPr>
        <p:spPr>
          <a:xfrm>
            <a:off x="2936092" y="2905967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14 ± 2.4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テキスト ボックス 310"/>
          <p:cNvSpPr txBox="1"/>
          <p:nvPr/>
        </p:nvSpPr>
        <p:spPr>
          <a:xfrm>
            <a:off x="2934556" y="316336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.26 ± 9.3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テキスト ボックス 311"/>
          <p:cNvSpPr txBox="1"/>
          <p:nvPr/>
        </p:nvSpPr>
        <p:spPr>
          <a:xfrm>
            <a:off x="3033165" y="367815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64 ± 0.3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864782" y="3935544"/>
            <a:ext cx="13383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1.84 ± 20.4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テキスト ボックス 313"/>
          <p:cNvSpPr txBox="1"/>
          <p:nvPr/>
        </p:nvSpPr>
        <p:spPr>
          <a:xfrm>
            <a:off x="2851134" y="4192937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8.91 ± 24.4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テキスト ボックス 314"/>
          <p:cNvSpPr txBox="1"/>
          <p:nvPr/>
        </p:nvSpPr>
        <p:spPr>
          <a:xfrm>
            <a:off x="2851134" y="4450331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8.64 ± 54.2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テキスト ボックス 315"/>
          <p:cNvSpPr txBox="1"/>
          <p:nvPr/>
        </p:nvSpPr>
        <p:spPr>
          <a:xfrm>
            <a:off x="2936092" y="4707725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.24 ± 5.7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テキスト ボックス 317"/>
          <p:cNvSpPr txBox="1"/>
          <p:nvPr/>
        </p:nvSpPr>
        <p:spPr>
          <a:xfrm>
            <a:off x="2936092" y="4965120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1.54 ± 9.0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2839020" y="5222514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7.21 ± 33.5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テキスト ボックス 319"/>
          <p:cNvSpPr txBox="1"/>
          <p:nvPr/>
        </p:nvSpPr>
        <p:spPr>
          <a:xfrm>
            <a:off x="2837486" y="5479908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6.16 ± 48.5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テキスト ボックス 320"/>
          <p:cNvSpPr txBox="1"/>
          <p:nvPr/>
        </p:nvSpPr>
        <p:spPr>
          <a:xfrm>
            <a:off x="2922444" y="5737301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.01 ± 4.7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テキスト ボックス 321"/>
          <p:cNvSpPr txBox="1"/>
          <p:nvPr/>
        </p:nvSpPr>
        <p:spPr>
          <a:xfrm>
            <a:off x="2922444" y="5994695"/>
            <a:ext cx="1261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4.64 ± 10.3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テキスト ボックス 322"/>
          <p:cNvSpPr txBox="1"/>
          <p:nvPr/>
        </p:nvSpPr>
        <p:spPr>
          <a:xfrm>
            <a:off x="2922444" y="6252089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.29 ± 6.1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2922444" y="650948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.06 ± 3.45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2922444" y="6766878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8.29 ± 6.1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2851134" y="342075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2.93 ± 20.4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テキスト ボックス 328"/>
          <p:cNvSpPr txBox="1"/>
          <p:nvPr/>
        </p:nvSpPr>
        <p:spPr>
          <a:xfrm>
            <a:off x="2922444" y="7281666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.54 ± 5.28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/>
          <p:cNvSpPr txBox="1"/>
          <p:nvPr/>
        </p:nvSpPr>
        <p:spPr>
          <a:xfrm>
            <a:off x="3005869" y="753905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66 ± 1.1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/>
          <p:cNvSpPr txBox="1"/>
          <p:nvPr/>
        </p:nvSpPr>
        <p:spPr>
          <a:xfrm>
            <a:off x="2908796" y="7796453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.18 ± 6.0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/>
          <p:cNvSpPr txBox="1"/>
          <p:nvPr/>
        </p:nvSpPr>
        <p:spPr>
          <a:xfrm>
            <a:off x="2730106" y="8053846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82.07 ± 168.13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テキスト ボックス 332"/>
          <p:cNvSpPr txBox="1"/>
          <p:nvPr/>
        </p:nvSpPr>
        <p:spPr>
          <a:xfrm>
            <a:off x="2711582" y="8311242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56.47 ± 394.9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テキスト ボックス 333"/>
          <p:cNvSpPr txBox="1"/>
          <p:nvPr/>
        </p:nvSpPr>
        <p:spPr>
          <a:xfrm>
            <a:off x="2810190" y="8568636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4.41 ± 61.87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テキスト ボックス 334"/>
          <p:cNvSpPr txBox="1"/>
          <p:nvPr/>
        </p:nvSpPr>
        <p:spPr>
          <a:xfrm>
            <a:off x="2810190" y="8826030"/>
            <a:ext cx="1351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5.74 ± 45.20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テキスト ボックス 335"/>
          <p:cNvSpPr txBox="1"/>
          <p:nvPr/>
        </p:nvSpPr>
        <p:spPr>
          <a:xfrm>
            <a:off x="2992221" y="90834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3 ± 0.04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テキスト ボックス 336"/>
          <p:cNvSpPr txBox="1"/>
          <p:nvPr/>
        </p:nvSpPr>
        <p:spPr>
          <a:xfrm>
            <a:off x="2992221" y="9340817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7 ± 0.02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8" name="テキスト ボックス 337"/>
          <p:cNvSpPr txBox="1"/>
          <p:nvPr/>
        </p:nvSpPr>
        <p:spPr>
          <a:xfrm>
            <a:off x="2992221" y="9598223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59 ± 0.3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テキスト ボックス 338"/>
          <p:cNvSpPr txBox="1"/>
          <p:nvPr/>
        </p:nvSpPr>
        <p:spPr>
          <a:xfrm>
            <a:off x="2922444" y="7024272"/>
            <a:ext cx="1172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.02 ± 5.49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テキスト ボックス 339"/>
          <p:cNvSpPr txBox="1"/>
          <p:nvPr/>
        </p:nvSpPr>
        <p:spPr>
          <a:xfrm>
            <a:off x="3033165" y="1104209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13 ± 1.14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7805156C-CB8D-4CF3-8CB5-E8935C35EC99}"/>
              </a:ext>
            </a:extLst>
          </p:cNvPr>
          <p:cNvSpPr txBox="1"/>
          <p:nvPr/>
        </p:nvSpPr>
        <p:spPr>
          <a:xfrm>
            <a:off x="0" y="0"/>
            <a:ext cx="311174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ata 3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EE100FFA-4243-4243-BE6E-3EF308F5F641}"/>
              </a:ext>
            </a:extLst>
          </p:cNvPr>
          <p:cNvSpPr txBox="1"/>
          <p:nvPr/>
        </p:nvSpPr>
        <p:spPr>
          <a:xfrm>
            <a:off x="0" y="472409"/>
            <a:ext cx="466794" cy="4617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ja-JP" altLang="en-US" sz="24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0398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</TotalTime>
  <Words>1356</Words>
  <Application>Microsoft Macintosh PowerPoint</Application>
  <PresentationFormat>A4 210 x 297 mm</PresentationFormat>
  <Paragraphs>421</Paragraphs>
  <Slides>5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2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Microsoft Office User</cp:lastModifiedBy>
  <cp:revision>22</cp:revision>
  <dcterms:created xsi:type="dcterms:W3CDTF">2018-11-25T06:35:28Z</dcterms:created>
  <dcterms:modified xsi:type="dcterms:W3CDTF">2019-07-25T00:59:28Z</dcterms:modified>
</cp:coreProperties>
</file>